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64" r:id="rId6"/>
    <p:sldId id="265" r:id="rId7"/>
    <p:sldId id="266" r:id="rId8"/>
    <p:sldId id="267" r:id="rId9"/>
  </p:sldIdLst>
  <p:sldSz cx="6858000" cy="9906000" type="A4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riv greenshpan" userId="04267bd6-eb40-4405-bb71-e4e8b5a7539f" providerId="ADAL" clId="{3DE075CA-B3EB-48A4-8282-399D78EA15C2}"/>
    <pc:docChg chg="addSld delSld modSld">
      <pc:chgData name="yariv greenshpan" userId="04267bd6-eb40-4405-bb71-e4e8b5a7539f" providerId="ADAL" clId="{3DE075CA-B3EB-48A4-8282-399D78EA15C2}" dt="2022-05-18T09:57:57.751" v="8" actId="20577"/>
      <pc:docMkLst>
        <pc:docMk/>
      </pc:docMkLst>
      <pc:sldChg chg="del">
        <pc:chgData name="yariv greenshpan" userId="04267bd6-eb40-4405-bb71-e4e8b5a7539f" providerId="ADAL" clId="{3DE075CA-B3EB-48A4-8282-399D78EA15C2}" dt="2022-05-18T09:56:32.994" v="0" actId="2696"/>
        <pc:sldMkLst>
          <pc:docMk/>
          <pc:sldMk cId="2622459733" sldId="263"/>
        </pc:sldMkLst>
      </pc:sldChg>
      <pc:sldChg chg="add">
        <pc:chgData name="yariv greenshpan" userId="04267bd6-eb40-4405-bb71-e4e8b5a7539f" providerId="ADAL" clId="{3DE075CA-B3EB-48A4-8282-399D78EA15C2}" dt="2022-05-18T09:56:42.932" v="1"/>
        <pc:sldMkLst>
          <pc:docMk/>
          <pc:sldMk cId="3365324240" sldId="264"/>
        </pc:sldMkLst>
      </pc:sldChg>
      <pc:sldChg chg="add">
        <pc:chgData name="yariv greenshpan" userId="04267bd6-eb40-4405-bb71-e4e8b5a7539f" providerId="ADAL" clId="{3DE075CA-B3EB-48A4-8282-399D78EA15C2}" dt="2022-05-18T09:57:00.822" v="2"/>
        <pc:sldMkLst>
          <pc:docMk/>
          <pc:sldMk cId="1073570247" sldId="265"/>
        </pc:sldMkLst>
      </pc:sldChg>
      <pc:sldChg chg="add">
        <pc:chgData name="yariv greenshpan" userId="04267bd6-eb40-4405-bb71-e4e8b5a7539f" providerId="ADAL" clId="{3DE075CA-B3EB-48A4-8282-399D78EA15C2}" dt="2022-05-18T09:57:22.149" v="3"/>
        <pc:sldMkLst>
          <pc:docMk/>
          <pc:sldMk cId="646193136" sldId="266"/>
        </pc:sldMkLst>
      </pc:sldChg>
      <pc:sldChg chg="modSp add">
        <pc:chgData name="yariv greenshpan" userId="04267bd6-eb40-4405-bb71-e4e8b5a7539f" providerId="ADAL" clId="{3DE075CA-B3EB-48A4-8282-399D78EA15C2}" dt="2022-05-18T09:57:57.751" v="8" actId="20577"/>
        <pc:sldMkLst>
          <pc:docMk/>
          <pc:sldMk cId="4233477906" sldId="267"/>
        </pc:sldMkLst>
        <pc:spChg chg="mod">
          <ac:chgData name="yariv greenshpan" userId="04267bd6-eb40-4405-bb71-e4e8b5a7539f" providerId="ADAL" clId="{3DE075CA-B3EB-48A4-8282-399D78EA15C2}" dt="2022-05-18T09:57:57.751" v="8" actId="20577"/>
          <ac:spMkLst>
            <pc:docMk/>
            <pc:sldMk cId="4233477906" sldId="267"/>
            <ac:spMk id="31" creationId="{6BE910B7-AE4A-40FE-B419-F3216A3A98F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024907-A77D-4845-9E16-8E0AB7FEFD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DA0FFF-7E1E-411B-94D4-B35F35B351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0D9DD4-64D8-45CE-86D2-13DCDA962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DC9EF6-90D4-463B-9D2B-5CF38777E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41C3BB-C3CE-4DE0-8CBB-4E76C89EB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36193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B3D56-83A5-4A87-B7CD-AE4A25DBE0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D706D2-3233-4F0B-AD8B-F9FCA1F1CA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BF473E-D1BF-46D0-AADE-FE6B050D5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12323D-C10E-407B-9D03-1F848C17D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7511A7-9601-4C45-8F06-8E77C1081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83127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76BC00-6601-4C7E-A041-51C3A0883D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C96B74-0AA9-4032-BFFF-A95F4EFBAA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AA3E2-86A6-4DF5-8F52-84DFA5207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ADC4A-2F98-4F81-B9FB-FDB198912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026968-684F-4136-993A-B472ADE67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10440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6C71AF-6FE6-45A1-A583-7E7A5EED34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55FEDD-A57B-4D01-AB3D-7905A759A5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D29481-FA71-4251-BA88-2B8EE95EE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89870C-837E-4EB1-A714-FB1EA2B34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5F32F0-FFFC-4314-B73F-DF8AEB14C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74826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060A9A-2A7A-42D8-8D2A-97C0EB20E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577DD1-29B7-4AD9-A2DE-BF55E46CE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7FD473-7DCB-4F94-8650-EFBB633E7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8E0DF0-6F4E-4E5F-8478-DDD3A4246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A9E00A-DA5A-4029-AEF9-DC193CE16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55424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A9A544-53AD-4AD3-B8C5-317A15587A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EB3E9F-BB64-464E-BF1B-79512057A4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D33B4E-0342-45D7-B607-24F00DC513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2F8EF-794E-4777-9D9A-0885A7C5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46D17D-4AA6-4AD5-9C10-D5B5A5B96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277DEC-32BF-42F4-86D2-1C1E0ACA0F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7694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776049-B6B6-44BD-BA4C-F9C383939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EED8D4-2A77-4619-A546-C3AD7B45D0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442BAC-03FD-4943-BE86-D4A041F07F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C0148C-F643-434A-AA14-5ECD7CAE0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930ED9-D197-4375-9B6B-C8034B2290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602B79-7D61-40F5-A7A3-24D04FC13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ED05C7-5021-4223-BCBB-81D86E3D4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156C2A-C462-4A8D-A5D4-ADBD3C777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21742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A71AE3-D812-4DED-B418-F6D32C31E4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0AC654-AE33-477B-9E76-01189D91D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88B4A4-39EA-40C4-883E-1FB04E5C3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0A325A-6927-419E-AC74-546EE1416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67010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1CE27C-A72A-4F84-B0BC-F82B5E717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C9ED5D-10CF-4FC0-B527-BCA019816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AF253B8-2BCB-4D8A-BC9D-64A6D4ADA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57914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5D6712-D6AC-4ED4-B303-FA9609C47D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DD69F2-AB53-461B-941F-4EFE532FB1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37ADC0-05BF-43E1-9B1E-1EA1B0A834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CDAB06-5A42-4017-BFA0-5506E2424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02AEFF-637F-4751-917D-057F621A9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8090D4-FACE-422B-A62B-ACCD48AA9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41283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C12C03-E83E-4E1C-A7FC-3824F2822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85D0FE-C13D-4E39-8DCC-0B4FE8BE1A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6AD21D-4588-49FD-8C23-54E1D64DB9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1E69FF-51F8-440E-AC65-1DA4DB214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79DBAE-3BA9-4DF7-A88B-6ECE2444E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197B6C-9F26-46D2-BF68-C8A86C724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03476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7F06CD-D64A-4FD0-A1B4-1F6030944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F1E71B-53F6-4DD5-BDE2-4D9060144C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7D7E23-5DD8-45F2-B855-31733343FB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C97C8-BAD4-4B7C-AC83-93826C5EBE4E}" type="datetimeFigureOut">
              <a:rPr lang="he-IL" smtClean="0"/>
              <a:t>ה'/תמוז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8F874E-79BD-4843-8C29-E0F6479FA6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92825C-62CE-4472-9DBF-1ACC0D6192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B7316-8F2F-4350-9F11-B4DC3BB0223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2264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41.png"/><Relationship Id="rId18" Type="http://schemas.openxmlformats.org/officeDocument/2006/relationships/image" Target="../media/image46.png"/><Relationship Id="rId26" Type="http://schemas.openxmlformats.org/officeDocument/2006/relationships/image" Target="../media/image54.png"/><Relationship Id="rId3" Type="http://schemas.openxmlformats.org/officeDocument/2006/relationships/image" Target="../media/image31.png"/><Relationship Id="rId21" Type="http://schemas.openxmlformats.org/officeDocument/2006/relationships/image" Target="../media/image49.png"/><Relationship Id="rId7" Type="http://schemas.openxmlformats.org/officeDocument/2006/relationships/image" Target="../media/image35.png"/><Relationship Id="rId12" Type="http://schemas.openxmlformats.org/officeDocument/2006/relationships/image" Target="../media/image40.png"/><Relationship Id="rId17" Type="http://schemas.openxmlformats.org/officeDocument/2006/relationships/image" Target="../media/image45.png"/><Relationship Id="rId25" Type="http://schemas.openxmlformats.org/officeDocument/2006/relationships/image" Target="../media/image53.png"/><Relationship Id="rId2" Type="http://schemas.openxmlformats.org/officeDocument/2006/relationships/image" Target="../media/image30.png"/><Relationship Id="rId16" Type="http://schemas.openxmlformats.org/officeDocument/2006/relationships/image" Target="../media/image44.png"/><Relationship Id="rId20" Type="http://schemas.openxmlformats.org/officeDocument/2006/relationships/image" Target="../media/image48.png"/><Relationship Id="rId29" Type="http://schemas.openxmlformats.org/officeDocument/2006/relationships/image" Target="../media/image5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4.png"/><Relationship Id="rId11" Type="http://schemas.openxmlformats.org/officeDocument/2006/relationships/image" Target="../media/image39.png"/><Relationship Id="rId24" Type="http://schemas.openxmlformats.org/officeDocument/2006/relationships/image" Target="../media/image52.png"/><Relationship Id="rId5" Type="http://schemas.openxmlformats.org/officeDocument/2006/relationships/image" Target="../media/image33.png"/><Relationship Id="rId15" Type="http://schemas.openxmlformats.org/officeDocument/2006/relationships/image" Target="../media/image43.png"/><Relationship Id="rId23" Type="http://schemas.openxmlformats.org/officeDocument/2006/relationships/image" Target="../media/image51.png"/><Relationship Id="rId28" Type="http://schemas.openxmlformats.org/officeDocument/2006/relationships/image" Target="../media/image56.png"/><Relationship Id="rId10" Type="http://schemas.openxmlformats.org/officeDocument/2006/relationships/image" Target="../media/image38.png"/><Relationship Id="rId19" Type="http://schemas.openxmlformats.org/officeDocument/2006/relationships/image" Target="../media/image47.png"/><Relationship Id="rId31" Type="http://schemas.openxmlformats.org/officeDocument/2006/relationships/image" Target="../media/image59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Relationship Id="rId14" Type="http://schemas.openxmlformats.org/officeDocument/2006/relationships/image" Target="../media/image42.png"/><Relationship Id="rId22" Type="http://schemas.openxmlformats.org/officeDocument/2006/relationships/image" Target="../media/image50.png"/><Relationship Id="rId27" Type="http://schemas.openxmlformats.org/officeDocument/2006/relationships/image" Target="../media/image55.png"/><Relationship Id="rId30" Type="http://schemas.openxmlformats.org/officeDocument/2006/relationships/image" Target="../media/image5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13" Type="http://schemas.openxmlformats.org/officeDocument/2006/relationships/image" Target="../media/image71.png"/><Relationship Id="rId18" Type="http://schemas.openxmlformats.org/officeDocument/2006/relationships/image" Target="../media/image76.png"/><Relationship Id="rId26" Type="http://schemas.openxmlformats.org/officeDocument/2006/relationships/image" Target="../media/image84.png"/><Relationship Id="rId3" Type="http://schemas.openxmlformats.org/officeDocument/2006/relationships/image" Target="../media/image61.png"/><Relationship Id="rId21" Type="http://schemas.openxmlformats.org/officeDocument/2006/relationships/image" Target="../media/image79.png"/><Relationship Id="rId7" Type="http://schemas.openxmlformats.org/officeDocument/2006/relationships/image" Target="../media/image65.png"/><Relationship Id="rId12" Type="http://schemas.openxmlformats.org/officeDocument/2006/relationships/image" Target="../media/image70.png"/><Relationship Id="rId17" Type="http://schemas.openxmlformats.org/officeDocument/2006/relationships/image" Target="../media/image75.png"/><Relationship Id="rId25" Type="http://schemas.openxmlformats.org/officeDocument/2006/relationships/image" Target="../media/image83.png"/><Relationship Id="rId2" Type="http://schemas.openxmlformats.org/officeDocument/2006/relationships/image" Target="../media/image60.png"/><Relationship Id="rId16" Type="http://schemas.openxmlformats.org/officeDocument/2006/relationships/image" Target="../media/image74.png"/><Relationship Id="rId20" Type="http://schemas.openxmlformats.org/officeDocument/2006/relationships/image" Target="../media/image78.png"/><Relationship Id="rId29" Type="http://schemas.openxmlformats.org/officeDocument/2006/relationships/image" Target="../media/image8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4.png"/><Relationship Id="rId11" Type="http://schemas.openxmlformats.org/officeDocument/2006/relationships/image" Target="../media/image69.png"/><Relationship Id="rId24" Type="http://schemas.openxmlformats.org/officeDocument/2006/relationships/image" Target="../media/image82.png"/><Relationship Id="rId5" Type="http://schemas.openxmlformats.org/officeDocument/2006/relationships/image" Target="../media/image63.png"/><Relationship Id="rId15" Type="http://schemas.openxmlformats.org/officeDocument/2006/relationships/image" Target="../media/image73.png"/><Relationship Id="rId23" Type="http://schemas.openxmlformats.org/officeDocument/2006/relationships/image" Target="../media/image81.png"/><Relationship Id="rId28" Type="http://schemas.openxmlformats.org/officeDocument/2006/relationships/image" Target="../media/image86.png"/><Relationship Id="rId10" Type="http://schemas.openxmlformats.org/officeDocument/2006/relationships/image" Target="../media/image68.png"/><Relationship Id="rId19" Type="http://schemas.openxmlformats.org/officeDocument/2006/relationships/image" Target="../media/image77.png"/><Relationship Id="rId4" Type="http://schemas.openxmlformats.org/officeDocument/2006/relationships/image" Target="../media/image62.png"/><Relationship Id="rId9" Type="http://schemas.openxmlformats.org/officeDocument/2006/relationships/image" Target="../media/image67.png"/><Relationship Id="rId14" Type="http://schemas.openxmlformats.org/officeDocument/2006/relationships/image" Target="../media/image72.png"/><Relationship Id="rId22" Type="http://schemas.openxmlformats.org/officeDocument/2006/relationships/image" Target="../media/image80.png"/><Relationship Id="rId27" Type="http://schemas.openxmlformats.org/officeDocument/2006/relationships/image" Target="../media/image85.png"/><Relationship Id="rId30" Type="http://schemas.openxmlformats.org/officeDocument/2006/relationships/image" Target="../media/image8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3.png"/><Relationship Id="rId5" Type="http://schemas.openxmlformats.org/officeDocument/2006/relationships/image" Target="../media/image92.png"/><Relationship Id="rId4" Type="http://schemas.openxmlformats.org/officeDocument/2006/relationships/image" Target="../media/image9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6BE910B7-AE4A-40FE-B419-F3216A3A98FD}"/>
              </a:ext>
            </a:extLst>
          </p:cNvPr>
          <p:cNvSpPr txBox="1"/>
          <p:nvPr/>
        </p:nvSpPr>
        <p:spPr>
          <a:xfrm>
            <a:off x="130994" y="6964234"/>
            <a:ext cx="6388100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Supplementary figure S1 – a. </a:t>
            </a:r>
            <a:r>
              <a:rPr lang="en-US" sz="1000" dirty="0"/>
              <a:t>the gating scheme used to calculate reporter expression</a:t>
            </a:r>
            <a:r>
              <a:rPr lang="en-US" sz="1000" b="1" dirty="0"/>
              <a:t>. </a:t>
            </a:r>
            <a:r>
              <a:rPr lang="en-US" sz="1000" dirty="0"/>
              <a:t> showing non stimulated HEK293T cells transduced with a RFP670 reporter under the control  G1K06H1 YB_TAT promotor and a </a:t>
            </a:r>
            <a:r>
              <a:rPr lang="en-US" sz="1000" dirty="0" err="1"/>
              <a:t>ZsGreen</a:t>
            </a:r>
            <a:r>
              <a:rPr lang="en-US" sz="1000" dirty="0"/>
              <a:t> reporter under the control of a ef1</a:t>
            </a:r>
            <a:r>
              <a:rPr lang="el-GR" sz="1000" dirty="0"/>
              <a:t>α</a:t>
            </a:r>
            <a:r>
              <a:rPr lang="en-US" sz="1000" dirty="0"/>
              <a:t> core promotor. A logic gate composed of FS-SS AND single AND NOT DAPI+ was used to define live cells. RFP670+ cells gated was set according to the </a:t>
            </a:r>
            <a:r>
              <a:rPr lang="en-US" sz="1000" dirty="0" err="1"/>
              <a:t>untransduced</a:t>
            </a:r>
            <a:r>
              <a:rPr lang="en-US" sz="1000" dirty="0"/>
              <a:t> cells.</a:t>
            </a:r>
            <a:r>
              <a:rPr lang="en-US" sz="1000" b="1" dirty="0"/>
              <a:t> b.</a:t>
            </a:r>
            <a:r>
              <a:rPr lang="en-US" sz="1000" dirty="0"/>
              <a:t> the %RFP670+ cells normalized to the </a:t>
            </a:r>
            <a:r>
              <a:rPr lang="en-US" sz="1000" dirty="0" err="1"/>
              <a:t>ZsGreen</a:t>
            </a:r>
            <a:r>
              <a:rPr lang="en-US" sz="1000" dirty="0"/>
              <a:t> positive cells. Average of triplicates, error bar indicate standard deviation . </a:t>
            </a:r>
            <a:r>
              <a:rPr lang="en-US" sz="1000" b="1" dirty="0"/>
              <a:t>c.</a:t>
            </a:r>
            <a:r>
              <a:rPr lang="en-US" sz="1000" dirty="0"/>
              <a:t>  Representative FACS plots for all three vectors in all 8 stimuli using the RFP670 reporter constructs</a:t>
            </a:r>
            <a:endParaRPr lang="he-IL" sz="1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9D8D297-159D-4F2D-976D-7D7F394FEA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571500"/>
            <a:ext cx="1440000" cy="1440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EBE455B-86CC-497C-94ED-5C4BEF8E27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4050" y="571500"/>
            <a:ext cx="1440000" cy="144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5E1E078-E7B7-41C9-8C56-9E14B9AB79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41400" y="571500"/>
            <a:ext cx="1440000" cy="144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8BD3989-885E-441E-B2E7-1CE3135066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28750" y="571500"/>
            <a:ext cx="1440000" cy="1440000"/>
          </a:xfrm>
          <a:prstGeom prst="rect">
            <a:avLst/>
          </a:prstGeom>
        </p:spPr>
      </p:pic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416DECF-A6BF-4B36-BD12-C1016A772AB2}"/>
              </a:ext>
            </a:extLst>
          </p:cNvPr>
          <p:cNvCxnSpPr>
            <a:cxnSpLocks/>
          </p:cNvCxnSpPr>
          <p:nvPr/>
        </p:nvCxnSpPr>
        <p:spPr>
          <a:xfrm>
            <a:off x="2430300" y="2749550"/>
            <a:ext cx="742950" cy="0"/>
          </a:xfrm>
          <a:prstGeom prst="line">
            <a:avLst/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5D3B369-924C-499D-9FB5-12F3FE9534E4}"/>
              </a:ext>
            </a:extLst>
          </p:cNvPr>
          <p:cNvSpPr txBox="1"/>
          <p:nvPr/>
        </p:nvSpPr>
        <p:spPr>
          <a:xfrm>
            <a:off x="130994" y="188615"/>
            <a:ext cx="280846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.</a:t>
            </a:r>
            <a:endParaRPr lang="he-IL" sz="1000" b="1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66EDCC43-50C7-4523-9C02-2277B994DB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3172" y="2263644"/>
            <a:ext cx="2880000" cy="155840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3930DEE-A00E-4AC6-B50C-57FF0F15D363}"/>
              </a:ext>
            </a:extLst>
          </p:cNvPr>
          <p:cNvSpPr txBox="1"/>
          <p:nvPr/>
        </p:nvSpPr>
        <p:spPr>
          <a:xfrm>
            <a:off x="130994" y="2025053"/>
            <a:ext cx="28725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b.</a:t>
            </a:r>
            <a:endParaRPr lang="he-IL" sz="1000" b="1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E5691C1-8894-4EC3-AEA0-0715F3D196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0513" y="4061082"/>
            <a:ext cx="828000" cy="828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1E4A7F3-533F-4344-A2F7-66C02B7D891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17282" y="4061082"/>
            <a:ext cx="828000" cy="828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5D18B29-CECC-4FC5-B0AA-DC6D40FC107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31511" y="4061082"/>
            <a:ext cx="828000" cy="828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0ED9820-1E18-425A-B19A-22151546B29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45740" y="4061082"/>
            <a:ext cx="828000" cy="8280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07559F8-C4CC-45B9-8253-7BE3FDE538C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59969" y="4061082"/>
            <a:ext cx="828000" cy="828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738CA86B-5A93-4493-B828-48F4E0DE64F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374198" y="4061082"/>
            <a:ext cx="828000" cy="828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2AC04D72-A42E-40B9-838C-1C5BBAEFFF6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88427" y="4061082"/>
            <a:ext cx="828000" cy="8280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EC023D4-9CB3-443E-B8D5-52640B241DB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002655" y="4061082"/>
            <a:ext cx="828000" cy="82800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369EBE10-36CC-4234-87EC-E59283455167}"/>
              </a:ext>
            </a:extLst>
          </p:cNvPr>
          <p:cNvSpPr txBox="1"/>
          <p:nvPr/>
        </p:nvSpPr>
        <p:spPr>
          <a:xfrm>
            <a:off x="339249" y="3892240"/>
            <a:ext cx="816249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No stimulation</a:t>
            </a:r>
            <a:endParaRPr lang="he-IL" sz="8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219E5B8-DBBD-4D72-8311-A0AFCD256926}"/>
              </a:ext>
            </a:extLst>
          </p:cNvPr>
          <p:cNvSpPr txBox="1"/>
          <p:nvPr/>
        </p:nvSpPr>
        <p:spPr>
          <a:xfrm>
            <a:off x="1374648" y="3892240"/>
            <a:ext cx="37382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endParaRPr lang="he-IL" sz="8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1452ED0-2D79-46F8-A9BC-4DD0E71FD684}"/>
              </a:ext>
            </a:extLst>
          </p:cNvPr>
          <p:cNvSpPr txBox="1"/>
          <p:nvPr/>
        </p:nvSpPr>
        <p:spPr>
          <a:xfrm>
            <a:off x="2159251" y="3887989"/>
            <a:ext cx="41069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4836E29-21A6-47A3-86F1-11ED4E04306F}"/>
              </a:ext>
            </a:extLst>
          </p:cNvPr>
          <p:cNvSpPr txBox="1"/>
          <p:nvPr/>
        </p:nvSpPr>
        <p:spPr>
          <a:xfrm>
            <a:off x="2885594" y="3887989"/>
            <a:ext cx="65114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r>
              <a:rPr lang="en-US" sz="800" b="1" dirty="0"/>
              <a:t>+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A8A2B05-8BA7-460F-A8A5-66AF557A8D21}"/>
              </a:ext>
            </a:extLst>
          </p:cNvPr>
          <p:cNvSpPr txBox="1"/>
          <p:nvPr/>
        </p:nvSpPr>
        <p:spPr>
          <a:xfrm>
            <a:off x="3763311" y="3893666"/>
            <a:ext cx="396262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hypo</a:t>
            </a:r>
            <a:endParaRPr lang="he-IL" sz="80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BA70C00-CEFD-4A81-8853-183D4C9CEAC9}"/>
              </a:ext>
            </a:extLst>
          </p:cNvPr>
          <p:cNvSpPr txBox="1"/>
          <p:nvPr/>
        </p:nvSpPr>
        <p:spPr>
          <a:xfrm>
            <a:off x="4432085" y="3892320"/>
            <a:ext cx="64633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 err="1"/>
              <a:t>Hypo+IFN</a:t>
            </a:r>
            <a:r>
              <a:rPr lang="el-GR" sz="800" b="1" dirty="0"/>
              <a:t>γ</a:t>
            </a:r>
            <a:endParaRPr lang="he-IL" sz="800" b="1" dirty="0"/>
          </a:p>
          <a:p>
            <a:pPr algn="ctr"/>
            <a:endParaRPr lang="he-IL" sz="8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ABAD82C-C058-45DA-A0D9-7CF62689D320}"/>
              </a:ext>
            </a:extLst>
          </p:cNvPr>
          <p:cNvSpPr txBox="1"/>
          <p:nvPr/>
        </p:nvSpPr>
        <p:spPr>
          <a:xfrm>
            <a:off x="5234265" y="3887989"/>
            <a:ext cx="705642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Hypo+ 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C5FA0D7-419B-4AE2-875C-28B13243B6E7}"/>
              </a:ext>
            </a:extLst>
          </p:cNvPr>
          <p:cNvSpPr txBox="1"/>
          <p:nvPr/>
        </p:nvSpPr>
        <p:spPr>
          <a:xfrm>
            <a:off x="5954241" y="3887316"/>
            <a:ext cx="914033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r>
              <a:rPr lang="en-US" sz="800" b="1" dirty="0"/>
              <a:t>+TNF</a:t>
            </a:r>
            <a:r>
              <a:rPr lang="el-GR" sz="800" b="1" dirty="0"/>
              <a:t>α</a:t>
            </a:r>
            <a:r>
              <a:rPr lang="en-US" sz="800" b="1" dirty="0"/>
              <a:t>+hypo</a:t>
            </a:r>
            <a:endParaRPr lang="he-IL" sz="800" b="1" dirty="0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FC83B880-4C01-42B9-8A3C-3B05CE266A7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23235" y="4940341"/>
            <a:ext cx="828000" cy="8280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381AC865-8D9D-4D1F-9D2F-ADA69F3BBF4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134581" y="4940341"/>
            <a:ext cx="828000" cy="828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D81C64C-4BCB-407E-A1A8-E93373F2B87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45927" y="4940341"/>
            <a:ext cx="828000" cy="8280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1479E24E-C90A-42DE-B369-BF22960F424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757273" y="4940341"/>
            <a:ext cx="828000" cy="828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65DD454-A02B-4E2B-8099-B9C3CFC5EE7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68619" y="4940341"/>
            <a:ext cx="828000" cy="8280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51C24155-4ADC-48E4-AB9F-E57AA14C0E38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379965" y="4940341"/>
            <a:ext cx="828000" cy="8280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21B21CC4-B75B-4DA5-81B6-5EA37409CAA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191311" y="4940341"/>
            <a:ext cx="828000" cy="8280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1B098DB7-64FA-4FF8-9D19-CD7A915711B1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002655" y="4940341"/>
            <a:ext cx="828000" cy="8280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32C5BD33-7DF0-49DF-A9E5-941503729CC3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42432" y="5779618"/>
            <a:ext cx="828000" cy="8280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F626C789-15DE-48E6-9AAE-F4A51B7CECEE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151035" y="5779618"/>
            <a:ext cx="828000" cy="8280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16080D41-020E-438E-B736-89E5E61D87BE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959638" y="5779618"/>
            <a:ext cx="828000" cy="8280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64D2D465-9DDB-4F31-B3B5-16CC8DFA0215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768241" y="5779618"/>
            <a:ext cx="828000" cy="8280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EA5B856C-DE0E-49C1-8988-55B295285C9A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576844" y="5779618"/>
            <a:ext cx="828000" cy="8280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699A9433-F7B2-4283-85B3-BBC9E2FB7B93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385447" y="5779618"/>
            <a:ext cx="828000" cy="8280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155A4C69-A8B1-453A-87B0-180B5000DF39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5194050" y="5779618"/>
            <a:ext cx="828000" cy="8280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B0DD278F-D566-47E0-A14B-330C64011C7D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6002655" y="5779618"/>
            <a:ext cx="828000" cy="828000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BC0219AF-D780-4C61-BF0F-818C3989BA45}"/>
              </a:ext>
            </a:extLst>
          </p:cNvPr>
          <p:cNvSpPr txBox="1"/>
          <p:nvPr/>
        </p:nvSpPr>
        <p:spPr>
          <a:xfrm rot="16200000">
            <a:off x="-32949" y="4341178"/>
            <a:ext cx="593432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Mini TK</a:t>
            </a:r>
            <a:endParaRPr lang="he-IL" sz="10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39C88C2-B230-433D-9C2E-6BD679F7AB7D}"/>
              </a:ext>
            </a:extLst>
          </p:cNvPr>
          <p:cNvSpPr txBox="1"/>
          <p:nvPr/>
        </p:nvSpPr>
        <p:spPr>
          <a:xfrm rot="16200000">
            <a:off x="-93062" y="5229533"/>
            <a:ext cx="713657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Mini CMV</a:t>
            </a:r>
            <a:endParaRPr lang="he-IL" sz="10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0AE138D-B9B1-4EFC-9AAF-169C56B3D710}"/>
              </a:ext>
            </a:extLst>
          </p:cNvPr>
          <p:cNvSpPr txBox="1"/>
          <p:nvPr/>
        </p:nvSpPr>
        <p:spPr>
          <a:xfrm rot="16200000">
            <a:off x="-54754" y="6074684"/>
            <a:ext cx="670376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YB_TATA</a:t>
            </a:r>
            <a:endParaRPr lang="he-IL" sz="1000" b="1" dirty="0"/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F790C744-8B8A-4103-BAB0-8BF97D172C14}"/>
              </a:ext>
            </a:extLst>
          </p:cNvPr>
          <p:cNvCxnSpPr/>
          <p:nvPr/>
        </p:nvCxnSpPr>
        <p:spPr>
          <a:xfrm flipV="1">
            <a:off x="188658" y="4019240"/>
            <a:ext cx="16668" cy="267727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3561CAFC-D50F-4275-B138-14FF001176B5}"/>
              </a:ext>
            </a:extLst>
          </p:cNvPr>
          <p:cNvCxnSpPr/>
          <p:nvPr/>
        </p:nvCxnSpPr>
        <p:spPr>
          <a:xfrm>
            <a:off x="181973" y="6696518"/>
            <a:ext cx="664868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C3459201-72EC-4208-91D0-DC8EF3C107C8}"/>
              </a:ext>
            </a:extLst>
          </p:cNvPr>
          <p:cNvSpPr txBox="1"/>
          <p:nvPr/>
        </p:nvSpPr>
        <p:spPr>
          <a:xfrm>
            <a:off x="3268863" y="6707266"/>
            <a:ext cx="582211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RFP670</a:t>
            </a:r>
            <a:endParaRPr lang="he-IL" sz="10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4F2F626-CA2B-4B81-BA06-71CB5B66DD3E}"/>
              </a:ext>
            </a:extLst>
          </p:cNvPr>
          <p:cNvSpPr txBox="1"/>
          <p:nvPr/>
        </p:nvSpPr>
        <p:spPr>
          <a:xfrm rot="16200000">
            <a:off x="-254762" y="5397041"/>
            <a:ext cx="620683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 err="1"/>
              <a:t>ZsGreen</a:t>
            </a:r>
            <a:endParaRPr lang="he-IL" sz="10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A31B4F0-134F-4FDA-8E71-2683A0E74D3A}"/>
              </a:ext>
            </a:extLst>
          </p:cNvPr>
          <p:cNvSpPr txBox="1"/>
          <p:nvPr/>
        </p:nvSpPr>
        <p:spPr>
          <a:xfrm>
            <a:off x="122679" y="3655338"/>
            <a:ext cx="27122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c.</a:t>
            </a:r>
            <a:endParaRPr lang="he-IL" sz="1000" b="1" dirty="0"/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3100CF76-6713-48D5-8B0B-FD3E86183D36}"/>
              </a:ext>
            </a:extLst>
          </p:cNvPr>
          <p:cNvCxnSpPr/>
          <p:nvPr/>
        </p:nvCxnSpPr>
        <p:spPr>
          <a:xfrm flipV="1">
            <a:off x="1390650" y="368300"/>
            <a:ext cx="0" cy="78105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811265C0-6B78-4252-857B-14B2598B832C}"/>
              </a:ext>
            </a:extLst>
          </p:cNvPr>
          <p:cNvCxnSpPr>
            <a:cxnSpLocks/>
          </p:cNvCxnSpPr>
          <p:nvPr/>
        </p:nvCxnSpPr>
        <p:spPr>
          <a:xfrm>
            <a:off x="1390650" y="368300"/>
            <a:ext cx="43581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66FFEFA3-A701-4E6E-B96F-CB1808D65917}"/>
              </a:ext>
            </a:extLst>
          </p:cNvPr>
          <p:cNvCxnSpPr>
            <a:cxnSpLocks/>
          </p:cNvCxnSpPr>
          <p:nvPr/>
        </p:nvCxnSpPr>
        <p:spPr>
          <a:xfrm flipV="1">
            <a:off x="2349496" y="368299"/>
            <a:ext cx="0" cy="100964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4F72737D-3F5B-4995-B02F-08E7AD059841}"/>
              </a:ext>
            </a:extLst>
          </p:cNvPr>
          <p:cNvSpPr txBox="1"/>
          <p:nvPr/>
        </p:nvSpPr>
        <p:spPr>
          <a:xfrm>
            <a:off x="4258413" y="368299"/>
            <a:ext cx="42030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NOT</a:t>
            </a:r>
            <a:endParaRPr lang="he-IL" sz="1000" b="1" dirty="0"/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F83BC200-A8B7-4CDB-935C-C10321AF2A0D}"/>
              </a:ext>
            </a:extLst>
          </p:cNvPr>
          <p:cNvCxnSpPr/>
          <p:nvPr/>
        </p:nvCxnSpPr>
        <p:spPr>
          <a:xfrm>
            <a:off x="5748750" y="368299"/>
            <a:ext cx="0" cy="203201"/>
          </a:xfrm>
          <a:prstGeom prst="straightConnector1">
            <a:avLst/>
          </a:prstGeom>
          <a:ln w="19050">
            <a:headEnd type="non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472E532B-7FE3-4600-A831-4A0F69A831E5}"/>
              </a:ext>
            </a:extLst>
          </p:cNvPr>
          <p:cNvCxnSpPr>
            <a:cxnSpLocks/>
          </p:cNvCxnSpPr>
          <p:nvPr/>
        </p:nvCxnSpPr>
        <p:spPr>
          <a:xfrm flipV="1">
            <a:off x="4603750" y="368300"/>
            <a:ext cx="0" cy="39052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EEE5F281-FA3A-4004-92E2-5E198ABD03B1}"/>
              </a:ext>
            </a:extLst>
          </p:cNvPr>
          <p:cNvSpPr txBox="1"/>
          <p:nvPr/>
        </p:nvSpPr>
        <p:spPr>
          <a:xfrm>
            <a:off x="1964793" y="368299"/>
            <a:ext cx="426720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ND</a:t>
            </a:r>
            <a:endParaRPr lang="he-IL" sz="1000" b="1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818F6C0-2579-4CA1-A2D5-ECC28B027342}"/>
              </a:ext>
            </a:extLst>
          </p:cNvPr>
          <p:cNvSpPr txBox="1"/>
          <p:nvPr/>
        </p:nvSpPr>
        <p:spPr>
          <a:xfrm>
            <a:off x="951513" y="359489"/>
            <a:ext cx="426720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ND</a:t>
            </a:r>
            <a:endParaRPr lang="he-IL" sz="1000" b="1" dirty="0"/>
          </a:p>
        </p:txBody>
      </p:sp>
    </p:spTree>
    <p:extLst>
      <p:ext uri="{BB962C8B-B14F-4D97-AF65-F5344CB8AC3E}">
        <p14:creationId xmlns:p14="http://schemas.microsoft.com/office/powerpoint/2010/main" val="3962045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6BE910B7-AE4A-40FE-B419-F3216A3A98FD}"/>
              </a:ext>
            </a:extLst>
          </p:cNvPr>
          <p:cNvSpPr txBox="1"/>
          <p:nvPr/>
        </p:nvSpPr>
        <p:spPr>
          <a:xfrm>
            <a:off x="205734" y="7845437"/>
            <a:ext cx="6388100" cy="116955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/>
            <a:r>
              <a:rPr lang="en-US" sz="1000" b="1" dirty="0"/>
              <a:t>Supplementary figure S2– the gating scheme used for the CAR expression and the CAR used: a. </a:t>
            </a:r>
            <a:r>
              <a:rPr lang="en-US" sz="1000" dirty="0"/>
              <a:t>a scheme of the CAR </a:t>
            </a:r>
            <a:r>
              <a:rPr lang="en-US" sz="1000" dirty="0" err="1"/>
              <a:t>used.SP</a:t>
            </a:r>
            <a:r>
              <a:rPr lang="en-US" sz="1000" dirty="0"/>
              <a:t>- IgG kapa signal peptide, </a:t>
            </a:r>
            <a:r>
              <a:rPr lang="en-US" sz="1000" dirty="0" err="1"/>
              <a:t>scFV</a:t>
            </a:r>
            <a:r>
              <a:rPr lang="en-US" sz="1000" dirty="0"/>
              <a:t> – single chain variable fragment, Tm – transmembrane domain  </a:t>
            </a:r>
            <a:r>
              <a:rPr lang="en-US" sz="1000" b="1" dirty="0"/>
              <a:t>b.</a:t>
            </a:r>
            <a:r>
              <a:rPr lang="en-US" sz="1000" dirty="0"/>
              <a:t> showing non stimulated HEK293T cells transduced with a Herceptin based CAR under the control G1K06H1 YB_TATA promoter and a </a:t>
            </a:r>
            <a:r>
              <a:rPr lang="en-US" sz="1000" dirty="0" err="1"/>
              <a:t>ZsGreen</a:t>
            </a:r>
            <a:r>
              <a:rPr lang="en-US" sz="1000" dirty="0"/>
              <a:t> reporter under the control of a ef1</a:t>
            </a:r>
            <a:r>
              <a:rPr lang="el-GR" sz="1000" dirty="0"/>
              <a:t>α</a:t>
            </a:r>
            <a:r>
              <a:rPr lang="en-US" sz="1000" dirty="0"/>
              <a:t> core promoter. A logic gate composed of FS-SS AND single AND NOT DAPI+ was used to define live cells. RFP670+ cells gated was set according to the </a:t>
            </a:r>
            <a:r>
              <a:rPr lang="en-US" sz="1000" dirty="0" err="1"/>
              <a:t>untransduced</a:t>
            </a:r>
            <a:r>
              <a:rPr lang="en-US" sz="1000" dirty="0"/>
              <a:t> cells </a:t>
            </a:r>
            <a:r>
              <a:rPr lang="en-US" sz="1000" b="1" dirty="0"/>
              <a:t>c.</a:t>
            </a:r>
            <a:r>
              <a:rPr lang="en-US" sz="1000" dirty="0"/>
              <a:t> synergism index for all three promoters. Calculated by dividing the %</a:t>
            </a:r>
            <a:r>
              <a:rPr lang="en-US" sz="1000" dirty="0" err="1"/>
              <a:t>Myc</a:t>
            </a:r>
            <a:r>
              <a:rPr lang="en-US" sz="1000" baseline="30000" dirty="0" err="1"/>
              <a:t>+</a:t>
            </a:r>
            <a:r>
              <a:rPr lang="en-US" sz="1000" baseline="-25000" dirty="0" err="1"/>
              <a:t>Hypo+IFN+TNF</a:t>
            </a:r>
            <a:r>
              <a:rPr lang="en-US" sz="1000" dirty="0"/>
              <a:t> by the sum of %</a:t>
            </a:r>
            <a:r>
              <a:rPr lang="en-US" sz="1000" dirty="0" err="1"/>
              <a:t>Myc</a:t>
            </a:r>
            <a:r>
              <a:rPr lang="en-US" sz="1000" baseline="30000" dirty="0" err="1"/>
              <a:t>+</a:t>
            </a:r>
            <a:r>
              <a:rPr lang="en-US" sz="1000" baseline="-25000" dirty="0" err="1"/>
              <a:t>Hypo</a:t>
            </a:r>
            <a:r>
              <a:rPr lang="en-US" sz="1000" dirty="0"/>
              <a:t>+ %</a:t>
            </a:r>
            <a:r>
              <a:rPr lang="en-US" sz="1000" dirty="0" err="1"/>
              <a:t>Myc</a:t>
            </a:r>
            <a:r>
              <a:rPr lang="en-US" sz="1000" baseline="30000" dirty="0" err="1"/>
              <a:t>+</a:t>
            </a:r>
            <a:r>
              <a:rPr lang="en-US" sz="1000" baseline="-25000" dirty="0" err="1"/>
              <a:t>IFN</a:t>
            </a:r>
            <a:r>
              <a:rPr lang="en-US" sz="1000" dirty="0"/>
              <a:t>+%</a:t>
            </a:r>
            <a:r>
              <a:rPr lang="en-US" sz="1000" dirty="0" err="1"/>
              <a:t>Myc</a:t>
            </a:r>
            <a:r>
              <a:rPr lang="en-US" sz="1000" baseline="30000" dirty="0" err="1"/>
              <a:t>+</a:t>
            </a:r>
            <a:r>
              <a:rPr lang="en-US" sz="1000" baseline="-25000" dirty="0" err="1"/>
              <a:t>TNF</a:t>
            </a:r>
            <a:r>
              <a:rPr lang="en-US" sz="1000" dirty="0"/>
              <a:t>, where the synergism threshold is defined by a result greater than 1.</a:t>
            </a:r>
            <a:endParaRPr lang="he-IL" sz="1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A949696-7770-4959-A368-D50B773E7D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718" y="1425280"/>
            <a:ext cx="1440000" cy="144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F79F650-36DD-4459-AEBF-224061A748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4068" y="1425280"/>
            <a:ext cx="1440000" cy="144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1FDD05E-D9BB-4034-83C9-7445C44481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1418" y="1425280"/>
            <a:ext cx="1440000" cy="144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5DB461F-DE05-442C-A3C0-BB436F16E7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28768" y="1425280"/>
            <a:ext cx="1440000" cy="1440000"/>
          </a:xfrm>
          <a:prstGeom prst="rect">
            <a:avLst/>
          </a:prstGeom>
        </p:spPr>
      </p:pic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416DECF-A6BF-4B36-BD12-C1016A772AB2}"/>
              </a:ext>
            </a:extLst>
          </p:cNvPr>
          <p:cNvCxnSpPr/>
          <p:nvPr/>
        </p:nvCxnSpPr>
        <p:spPr>
          <a:xfrm flipV="1">
            <a:off x="1390650" y="1235075"/>
            <a:ext cx="0" cy="78105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84F5C0E-1BE0-4544-97B3-2D564359FBBB}"/>
              </a:ext>
            </a:extLst>
          </p:cNvPr>
          <p:cNvCxnSpPr>
            <a:cxnSpLocks/>
          </p:cNvCxnSpPr>
          <p:nvPr/>
        </p:nvCxnSpPr>
        <p:spPr>
          <a:xfrm>
            <a:off x="1390650" y="1235075"/>
            <a:ext cx="43581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19D8393-C4B2-4605-8A77-DE1D6FD96446}"/>
              </a:ext>
            </a:extLst>
          </p:cNvPr>
          <p:cNvCxnSpPr>
            <a:cxnSpLocks/>
          </p:cNvCxnSpPr>
          <p:nvPr/>
        </p:nvCxnSpPr>
        <p:spPr>
          <a:xfrm flipV="1">
            <a:off x="2216150" y="1235075"/>
            <a:ext cx="0" cy="10287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A9BFE51-4C35-4673-8D9A-FD76938A2312}"/>
              </a:ext>
            </a:extLst>
          </p:cNvPr>
          <p:cNvCxnSpPr>
            <a:cxnSpLocks/>
          </p:cNvCxnSpPr>
          <p:nvPr/>
        </p:nvCxnSpPr>
        <p:spPr>
          <a:xfrm flipH="1">
            <a:off x="2216151" y="2263775"/>
            <a:ext cx="27939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FB82EEF-3863-4730-9697-82980F86802F}"/>
              </a:ext>
            </a:extLst>
          </p:cNvPr>
          <p:cNvCxnSpPr>
            <a:cxnSpLocks/>
          </p:cNvCxnSpPr>
          <p:nvPr/>
        </p:nvCxnSpPr>
        <p:spPr>
          <a:xfrm flipV="1">
            <a:off x="4603750" y="1235075"/>
            <a:ext cx="0" cy="39052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C9FE2A16-B891-4B5A-88E9-3686CA3D8964}"/>
              </a:ext>
            </a:extLst>
          </p:cNvPr>
          <p:cNvSpPr txBox="1"/>
          <p:nvPr/>
        </p:nvSpPr>
        <p:spPr>
          <a:xfrm>
            <a:off x="4258413" y="1235074"/>
            <a:ext cx="38343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Not</a:t>
            </a:r>
            <a:endParaRPr lang="he-IL" sz="1000" b="1" dirty="0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E752055B-E4B6-4339-A803-88935ED7682F}"/>
              </a:ext>
            </a:extLst>
          </p:cNvPr>
          <p:cNvCxnSpPr>
            <a:cxnSpLocks/>
          </p:cNvCxnSpPr>
          <p:nvPr/>
        </p:nvCxnSpPr>
        <p:spPr>
          <a:xfrm>
            <a:off x="5748750" y="1235074"/>
            <a:ext cx="0" cy="203201"/>
          </a:xfrm>
          <a:prstGeom prst="straightConnector1">
            <a:avLst/>
          </a:prstGeom>
          <a:ln w="19050">
            <a:headEnd type="non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2F5B1D3C-81D5-4AA0-B1AA-365BD6CFF3FD}"/>
              </a:ext>
            </a:extLst>
          </p:cNvPr>
          <p:cNvSpPr txBox="1"/>
          <p:nvPr/>
        </p:nvSpPr>
        <p:spPr>
          <a:xfrm>
            <a:off x="130994" y="0"/>
            <a:ext cx="295274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.</a:t>
            </a:r>
            <a:endParaRPr lang="he-IL" sz="1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8B5C11C-0E75-42F2-AC8E-AA814C6437A2}"/>
              </a:ext>
            </a:extLst>
          </p:cNvPr>
          <p:cNvSpPr txBox="1"/>
          <p:nvPr/>
        </p:nvSpPr>
        <p:spPr>
          <a:xfrm>
            <a:off x="120780" y="915393"/>
            <a:ext cx="290464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B.</a:t>
            </a:r>
            <a:endParaRPr lang="he-IL" sz="1000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FE9695A-7064-4616-B295-47AF79FE5E9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2645" y="332151"/>
            <a:ext cx="4402845" cy="30937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D884551-C514-4176-844A-A3370987D24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0764" y="6130065"/>
            <a:ext cx="1878441" cy="15804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019CB23A-5C6B-400E-85CC-71E6DDC004EB}"/>
              </a:ext>
            </a:extLst>
          </p:cNvPr>
          <p:cNvSpPr txBox="1"/>
          <p:nvPr/>
        </p:nvSpPr>
        <p:spPr>
          <a:xfrm>
            <a:off x="10484" y="2909224"/>
            <a:ext cx="373832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C.</a:t>
            </a:r>
            <a:endParaRPr lang="he-IL" sz="1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685BE93-C694-4324-9901-A47AEA845BF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8200" y="3325787"/>
            <a:ext cx="828000" cy="828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5DA35F8-B047-4F2E-8604-CCF938CC991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47414" y="3325787"/>
            <a:ext cx="828000" cy="828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C6C3F27-F0A4-4B81-A339-6E9CD08B1BD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36628" y="3325787"/>
            <a:ext cx="828000" cy="828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464CDCE-C3BD-43B6-BD2B-38FA84D47E5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25842" y="3325787"/>
            <a:ext cx="828000" cy="828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F9DDFAD-D518-4E96-929E-A0C64BE1756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15056" y="3325787"/>
            <a:ext cx="828000" cy="828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F09E32C-1935-4895-B6E4-8A88F571986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04270" y="3325787"/>
            <a:ext cx="828000" cy="828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C47CF2B-164A-4A02-B9F2-1B9AB88A633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93484" y="3325787"/>
            <a:ext cx="828000" cy="828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77AEB92-42EA-4715-A9D0-760DA48E1B4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882700" y="3325787"/>
            <a:ext cx="828000" cy="8280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30EA87C-4F62-4DBC-B721-44FEE3B5D81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69938" y="4116021"/>
            <a:ext cx="828000" cy="828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9903E719-E359-40AE-8D6B-E3C8F85016E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157475" y="4116021"/>
            <a:ext cx="828000" cy="828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FDEC052E-EFAF-4C82-B737-25D851C743C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945012" y="4116021"/>
            <a:ext cx="828000" cy="8280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BAFBB280-FC55-489B-A533-6B125962DCF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732549" y="4116021"/>
            <a:ext cx="828000" cy="8280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CA3009C-3892-45EE-944B-71F102E0603D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20086" y="4116021"/>
            <a:ext cx="828000" cy="82800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611BB3CF-819F-46F2-B377-23301D3A9442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307623" y="4116021"/>
            <a:ext cx="828000" cy="8280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FA5F466F-E5DF-4862-B3C2-C88C89079771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095160" y="4116021"/>
            <a:ext cx="828000" cy="82800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556B43C5-4D42-4AC3-9BBF-947D33E593D7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882700" y="4116021"/>
            <a:ext cx="828000" cy="8280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F14CE351-A6D3-45DC-80A3-A0118D56F1B7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68137" y="4903764"/>
            <a:ext cx="828000" cy="8280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0C767A20-0D5B-4FFB-8F92-39D7A7C239EB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155932" y="4903764"/>
            <a:ext cx="828000" cy="828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26652D65-71EB-4709-A3C1-CB134A704D07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943727" y="4903764"/>
            <a:ext cx="828000" cy="828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33271529-A4A3-4CDD-A21B-8C7990D37D7D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731522" y="4903764"/>
            <a:ext cx="828000" cy="8280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677530FD-3418-401F-A06C-D24E4428A664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519317" y="4903764"/>
            <a:ext cx="828000" cy="8280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DD66F155-A51B-4AA8-BC20-195644A405C3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307112" y="4903764"/>
            <a:ext cx="828000" cy="828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1A96FCDF-4A1C-4CF6-A414-4B4D2AF92014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5094907" y="4903764"/>
            <a:ext cx="828000" cy="8280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DC705E4D-31B0-4ABC-9784-95DC0F72AA7A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5882700" y="4903764"/>
            <a:ext cx="828000" cy="828000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058C2693-5FF9-48CC-9AE7-522A90D4F333}"/>
              </a:ext>
            </a:extLst>
          </p:cNvPr>
          <p:cNvSpPr txBox="1"/>
          <p:nvPr/>
        </p:nvSpPr>
        <p:spPr>
          <a:xfrm>
            <a:off x="347991" y="3117162"/>
            <a:ext cx="816249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No stimulation</a:t>
            </a:r>
            <a:endParaRPr lang="he-IL" sz="8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648F84D-7FE1-43B8-816E-CBD7292B1941}"/>
              </a:ext>
            </a:extLst>
          </p:cNvPr>
          <p:cNvSpPr txBox="1"/>
          <p:nvPr/>
        </p:nvSpPr>
        <p:spPr>
          <a:xfrm>
            <a:off x="1383390" y="3117162"/>
            <a:ext cx="37382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endParaRPr lang="he-IL" sz="8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335C2B4-FA90-41B5-B8C0-278C6AA7EBEE}"/>
              </a:ext>
            </a:extLst>
          </p:cNvPr>
          <p:cNvSpPr txBox="1"/>
          <p:nvPr/>
        </p:nvSpPr>
        <p:spPr>
          <a:xfrm>
            <a:off x="2167993" y="3112911"/>
            <a:ext cx="41069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DCE37E4-704F-4EDF-8545-733035A8A9A2}"/>
              </a:ext>
            </a:extLst>
          </p:cNvPr>
          <p:cNvSpPr txBox="1"/>
          <p:nvPr/>
        </p:nvSpPr>
        <p:spPr>
          <a:xfrm>
            <a:off x="2894336" y="3112911"/>
            <a:ext cx="65114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r>
              <a:rPr lang="en-US" sz="800" b="1" dirty="0"/>
              <a:t>+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9722DD3-9CDC-4955-BC4A-D27723D78A1F}"/>
              </a:ext>
            </a:extLst>
          </p:cNvPr>
          <p:cNvSpPr txBox="1"/>
          <p:nvPr/>
        </p:nvSpPr>
        <p:spPr>
          <a:xfrm>
            <a:off x="3772053" y="3118588"/>
            <a:ext cx="396262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hypo</a:t>
            </a:r>
            <a:endParaRPr lang="he-IL" sz="8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77EDF62-442B-4FCE-9F53-1A2C7E5336BC}"/>
              </a:ext>
            </a:extLst>
          </p:cNvPr>
          <p:cNvSpPr txBox="1"/>
          <p:nvPr/>
        </p:nvSpPr>
        <p:spPr>
          <a:xfrm>
            <a:off x="4440827" y="3117242"/>
            <a:ext cx="64633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 err="1"/>
              <a:t>Hypo+IFN</a:t>
            </a:r>
            <a:r>
              <a:rPr lang="el-GR" sz="800" b="1" dirty="0"/>
              <a:t>γ</a:t>
            </a:r>
            <a:endParaRPr lang="he-IL" sz="800" b="1" dirty="0"/>
          </a:p>
          <a:p>
            <a:pPr algn="ctr"/>
            <a:endParaRPr lang="he-IL" sz="800" b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64A9617-8808-4B55-94C4-649685179AA3}"/>
              </a:ext>
            </a:extLst>
          </p:cNvPr>
          <p:cNvSpPr txBox="1"/>
          <p:nvPr/>
        </p:nvSpPr>
        <p:spPr>
          <a:xfrm>
            <a:off x="5243007" y="3112911"/>
            <a:ext cx="705642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Hypo+ 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15E65A8-B1C9-42F7-A392-C6FB29A65ABE}"/>
              </a:ext>
            </a:extLst>
          </p:cNvPr>
          <p:cNvSpPr txBox="1"/>
          <p:nvPr/>
        </p:nvSpPr>
        <p:spPr>
          <a:xfrm>
            <a:off x="5962983" y="3112238"/>
            <a:ext cx="914033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r>
              <a:rPr lang="en-US" sz="800" b="1" dirty="0"/>
              <a:t>+TNF</a:t>
            </a:r>
            <a:r>
              <a:rPr lang="el-GR" sz="800" b="1" dirty="0"/>
              <a:t>α</a:t>
            </a:r>
            <a:r>
              <a:rPr lang="en-US" sz="800" b="1" dirty="0"/>
              <a:t>+hypo</a:t>
            </a:r>
            <a:endParaRPr lang="he-IL" sz="8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4D45A00-23D4-4CE3-B376-F7F0B01FD308}"/>
              </a:ext>
            </a:extLst>
          </p:cNvPr>
          <p:cNvSpPr txBox="1"/>
          <p:nvPr/>
        </p:nvSpPr>
        <p:spPr>
          <a:xfrm rot="16200000">
            <a:off x="-24207" y="3566100"/>
            <a:ext cx="593432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Mini TK</a:t>
            </a:r>
            <a:endParaRPr lang="he-IL" sz="10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BD2569C-2F62-473B-995D-E8E87826C3E6}"/>
              </a:ext>
            </a:extLst>
          </p:cNvPr>
          <p:cNvSpPr txBox="1"/>
          <p:nvPr/>
        </p:nvSpPr>
        <p:spPr>
          <a:xfrm rot="16200000">
            <a:off x="-84320" y="4454455"/>
            <a:ext cx="713657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Mini CMV</a:t>
            </a:r>
            <a:endParaRPr lang="he-IL" sz="10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23F4B22-3B80-4F51-B140-3E24F4375768}"/>
              </a:ext>
            </a:extLst>
          </p:cNvPr>
          <p:cNvSpPr txBox="1"/>
          <p:nvPr/>
        </p:nvSpPr>
        <p:spPr>
          <a:xfrm rot="16200000">
            <a:off x="-46012" y="5299606"/>
            <a:ext cx="670376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YB_TATA</a:t>
            </a:r>
            <a:endParaRPr lang="he-IL" sz="1000" b="1" dirty="0"/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7B3E9700-4678-456D-A5BA-66B31B03A16A}"/>
              </a:ext>
            </a:extLst>
          </p:cNvPr>
          <p:cNvCxnSpPr/>
          <p:nvPr/>
        </p:nvCxnSpPr>
        <p:spPr>
          <a:xfrm flipV="1">
            <a:off x="197400" y="3244162"/>
            <a:ext cx="16668" cy="267727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337706DE-E4C4-44A6-870F-B39007E7258F}"/>
              </a:ext>
            </a:extLst>
          </p:cNvPr>
          <p:cNvCxnSpPr/>
          <p:nvPr/>
        </p:nvCxnSpPr>
        <p:spPr>
          <a:xfrm>
            <a:off x="190715" y="5921440"/>
            <a:ext cx="664868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C73EB06E-86F1-45B4-AD40-B0B1E7066A40}"/>
              </a:ext>
            </a:extLst>
          </p:cNvPr>
          <p:cNvSpPr txBox="1"/>
          <p:nvPr/>
        </p:nvSpPr>
        <p:spPr>
          <a:xfrm>
            <a:off x="3277605" y="5932188"/>
            <a:ext cx="582211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RFP670</a:t>
            </a:r>
            <a:endParaRPr lang="he-IL" sz="1000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F8A7902-52D3-4558-B391-F911F2EB1FCF}"/>
              </a:ext>
            </a:extLst>
          </p:cNvPr>
          <p:cNvSpPr txBox="1"/>
          <p:nvPr/>
        </p:nvSpPr>
        <p:spPr>
          <a:xfrm rot="16200000">
            <a:off x="-246020" y="4621963"/>
            <a:ext cx="620683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 err="1"/>
              <a:t>ZsGreen</a:t>
            </a:r>
            <a:endParaRPr lang="he-IL" sz="1000" b="1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9FF30D1-C977-4A7B-A3A2-69DB889CED2A}"/>
              </a:ext>
            </a:extLst>
          </p:cNvPr>
          <p:cNvSpPr txBox="1"/>
          <p:nvPr/>
        </p:nvSpPr>
        <p:spPr>
          <a:xfrm>
            <a:off x="27152" y="5995093"/>
            <a:ext cx="373832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D.</a:t>
            </a:r>
            <a:endParaRPr lang="he-IL" sz="1000" b="1" dirty="0"/>
          </a:p>
        </p:txBody>
      </p:sp>
    </p:spTree>
    <p:extLst>
      <p:ext uri="{BB962C8B-B14F-4D97-AF65-F5344CB8AC3E}">
        <p14:creationId xmlns:p14="http://schemas.microsoft.com/office/powerpoint/2010/main" val="33653242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98F860E-C1BC-4CE4-BEB4-FCF4BBC92F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3786" y="633513"/>
            <a:ext cx="1620000" cy="1620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2E2916C-41B2-4020-A613-08B0C2081E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931" y="633513"/>
            <a:ext cx="1620000" cy="1620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167A21D-F8A9-4FE2-9D44-DF91471504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7570" y="633513"/>
            <a:ext cx="1597577" cy="162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BFF096D-DAC3-4B34-A356-01E6FB8179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2426" y="633513"/>
            <a:ext cx="1620000" cy="1620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BE910B7-AE4A-40FE-B419-F3216A3A98FD}"/>
              </a:ext>
            </a:extLst>
          </p:cNvPr>
          <p:cNvSpPr txBox="1"/>
          <p:nvPr/>
        </p:nvSpPr>
        <p:spPr>
          <a:xfrm>
            <a:off x="119586" y="7554826"/>
            <a:ext cx="6388100" cy="116955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Supplementary figure S3 –  a. </a:t>
            </a:r>
            <a:r>
              <a:rPr lang="en-US" sz="1000" dirty="0"/>
              <a:t>the gating scheme used for reporter expression in human primary T cells </a:t>
            </a:r>
            <a:r>
              <a:rPr lang="en-US" sz="1000" b="1" dirty="0"/>
              <a:t>. </a:t>
            </a:r>
            <a:r>
              <a:rPr lang="en-US" sz="1000" dirty="0"/>
              <a:t>showing non stimulated human primary T cells transduced with a RFP670 reporter under the control G1K06H1 YB_TAT promotor and a </a:t>
            </a:r>
            <a:r>
              <a:rPr lang="en-US" sz="1000" dirty="0" err="1"/>
              <a:t>ZsGreen</a:t>
            </a:r>
            <a:r>
              <a:rPr lang="en-US" sz="1000" dirty="0"/>
              <a:t> reporter under the control of a ef1</a:t>
            </a:r>
            <a:r>
              <a:rPr lang="el-GR" sz="1000" dirty="0"/>
              <a:t>α</a:t>
            </a:r>
            <a:r>
              <a:rPr lang="en-US" sz="1000" dirty="0"/>
              <a:t> core promotor. A logic gate composed of FS-SS AND single AND NOT DAPI+ was used to define live cells. RFP670+ cells gated was set according to the </a:t>
            </a:r>
            <a:r>
              <a:rPr lang="en-US" sz="1000" dirty="0" err="1"/>
              <a:t>untransduced</a:t>
            </a:r>
            <a:r>
              <a:rPr lang="en-US" sz="1000" dirty="0"/>
              <a:t> cells </a:t>
            </a:r>
            <a:r>
              <a:rPr lang="en-US" sz="1000" b="1" dirty="0"/>
              <a:t>b.</a:t>
            </a:r>
            <a:r>
              <a:rPr lang="en-US" sz="1000" dirty="0"/>
              <a:t> average from quadruplicates of the CD107a+ cells from  the </a:t>
            </a:r>
            <a:r>
              <a:rPr lang="en-US" sz="1000" dirty="0" err="1"/>
              <a:t>ZsGreen</a:t>
            </a:r>
            <a:r>
              <a:rPr lang="en-US" sz="1000" dirty="0"/>
              <a:t> positive fraction, normalized to the total %</a:t>
            </a:r>
            <a:r>
              <a:rPr lang="en-US" sz="1000" dirty="0" err="1"/>
              <a:t>ZsGreen</a:t>
            </a:r>
            <a:r>
              <a:rPr lang="en-US" sz="1000" dirty="0"/>
              <a:t> positive cells. Cells were incubated for 4 hours with PBS or anti CD3 OKT3 to test for the minimum and maximum possible response of the cells. error bar indicate standard deviation</a:t>
            </a:r>
            <a:endParaRPr lang="he-IL" sz="1000" b="1" dirty="0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416DECF-A6BF-4B36-BD12-C1016A772AB2}"/>
              </a:ext>
            </a:extLst>
          </p:cNvPr>
          <p:cNvCxnSpPr/>
          <p:nvPr/>
        </p:nvCxnSpPr>
        <p:spPr>
          <a:xfrm flipV="1">
            <a:off x="1390650" y="368300"/>
            <a:ext cx="0" cy="78105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84F5C0E-1BE0-4544-97B3-2D564359FBBB}"/>
              </a:ext>
            </a:extLst>
          </p:cNvPr>
          <p:cNvCxnSpPr>
            <a:cxnSpLocks/>
          </p:cNvCxnSpPr>
          <p:nvPr/>
        </p:nvCxnSpPr>
        <p:spPr>
          <a:xfrm>
            <a:off x="1390650" y="368300"/>
            <a:ext cx="43581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19D8393-C4B2-4605-8A77-DE1D6FD96446}"/>
              </a:ext>
            </a:extLst>
          </p:cNvPr>
          <p:cNvCxnSpPr>
            <a:cxnSpLocks/>
          </p:cNvCxnSpPr>
          <p:nvPr/>
        </p:nvCxnSpPr>
        <p:spPr>
          <a:xfrm flipV="1">
            <a:off x="2216150" y="368300"/>
            <a:ext cx="0" cy="10287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A9BFE51-4C35-4673-8D9A-FD76938A2312}"/>
              </a:ext>
            </a:extLst>
          </p:cNvPr>
          <p:cNvCxnSpPr>
            <a:cxnSpLocks/>
          </p:cNvCxnSpPr>
          <p:nvPr/>
        </p:nvCxnSpPr>
        <p:spPr>
          <a:xfrm flipH="1">
            <a:off x="2216151" y="1397000"/>
            <a:ext cx="27939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FB82EEF-3863-4730-9697-82980F86802F}"/>
              </a:ext>
            </a:extLst>
          </p:cNvPr>
          <p:cNvCxnSpPr>
            <a:cxnSpLocks/>
          </p:cNvCxnSpPr>
          <p:nvPr/>
        </p:nvCxnSpPr>
        <p:spPr>
          <a:xfrm flipV="1">
            <a:off x="4603750" y="368300"/>
            <a:ext cx="0" cy="39052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C9FE2A16-B891-4B5A-88E9-3686CA3D8964}"/>
              </a:ext>
            </a:extLst>
          </p:cNvPr>
          <p:cNvSpPr txBox="1"/>
          <p:nvPr/>
        </p:nvSpPr>
        <p:spPr>
          <a:xfrm>
            <a:off x="4258413" y="368299"/>
            <a:ext cx="38343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Not</a:t>
            </a:r>
            <a:endParaRPr lang="he-IL" sz="1000" b="1" dirty="0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E752055B-E4B6-4339-A803-88935ED7682F}"/>
              </a:ext>
            </a:extLst>
          </p:cNvPr>
          <p:cNvCxnSpPr>
            <a:cxnSpLocks/>
          </p:cNvCxnSpPr>
          <p:nvPr/>
        </p:nvCxnSpPr>
        <p:spPr>
          <a:xfrm>
            <a:off x="5748750" y="368299"/>
            <a:ext cx="0" cy="203201"/>
          </a:xfrm>
          <a:prstGeom prst="straightConnector1">
            <a:avLst/>
          </a:prstGeom>
          <a:ln w="19050">
            <a:headEnd type="non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E2CB83BF-0D75-462D-92E6-10C0A59DB0B1}"/>
              </a:ext>
            </a:extLst>
          </p:cNvPr>
          <p:cNvSpPr txBox="1"/>
          <p:nvPr/>
        </p:nvSpPr>
        <p:spPr>
          <a:xfrm>
            <a:off x="127192" y="388229"/>
            <a:ext cx="280846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.</a:t>
            </a:r>
            <a:endParaRPr lang="he-IL" sz="1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57519C4-7404-4802-B1D0-5A6112C147EF}"/>
              </a:ext>
            </a:extLst>
          </p:cNvPr>
          <p:cNvSpPr txBox="1"/>
          <p:nvPr/>
        </p:nvSpPr>
        <p:spPr>
          <a:xfrm>
            <a:off x="161793" y="4498425"/>
            <a:ext cx="27122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c.</a:t>
            </a:r>
            <a:endParaRPr lang="he-IL" sz="1000" b="1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A7D3296-5592-4FEE-AF06-0E33F0678CF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9373" y="4932476"/>
            <a:ext cx="792000" cy="792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15D17CB-BE14-4165-B627-A4E3E79502B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09452" y="4932476"/>
            <a:ext cx="792000" cy="792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F04EA86-995B-4CB9-BEA2-1F8F362824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19531" y="4932476"/>
            <a:ext cx="792000" cy="792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CDA8D83-AF30-49AB-AE66-CD8298BCDF3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29610" y="4932476"/>
            <a:ext cx="792000" cy="792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86D46CA-D499-4A36-AE57-1BEED8CA9F6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39689" y="4932476"/>
            <a:ext cx="792000" cy="792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7DAE21D-C71D-4106-98CF-C7664C8BD06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49768" y="4932476"/>
            <a:ext cx="792000" cy="792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6F06F43-21DC-4601-933F-0BED62DBE5D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59847" y="4932476"/>
            <a:ext cx="792000" cy="792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C13AE85-0C1A-44CE-BD05-BA8721D3938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969923" y="4932476"/>
            <a:ext cx="792000" cy="79200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1122B3AD-C87F-41D6-A88C-1BEB35D2E42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99373" y="5728802"/>
            <a:ext cx="792000" cy="7920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D2461E0A-D66B-4FFD-ABA5-D5CD4A680F8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09452" y="5728802"/>
            <a:ext cx="792000" cy="7920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F7CD79DE-29DA-41B7-929E-A961DB6FA5B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919531" y="5728802"/>
            <a:ext cx="792000" cy="792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6C4494A3-BD15-4AD1-A932-8206EB3649B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729610" y="5728802"/>
            <a:ext cx="792000" cy="792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78123E0F-F95C-4CA4-91DD-D9E0092461C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539689" y="5728802"/>
            <a:ext cx="792000" cy="7920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2965E4D9-5ACE-4D3F-8368-D528FD383BF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349768" y="5728802"/>
            <a:ext cx="792000" cy="7920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0BC6CE6-C799-422D-AD59-5DF83E8B700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159847" y="5728802"/>
            <a:ext cx="792000" cy="792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54D12F2-4909-426B-9D18-E39F3A42C4AE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969923" y="5728802"/>
            <a:ext cx="792000" cy="792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B783ADC7-2C5E-41FA-A5B1-67605190DF65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20894" y="6530024"/>
            <a:ext cx="792000" cy="7920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1E18C301-83A4-45AA-8125-8130BC0BC43F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127898" y="6530024"/>
            <a:ext cx="792000" cy="7920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2714CE46-933B-455D-B954-F7F4AEC3C695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934902" y="6530024"/>
            <a:ext cx="792000" cy="7920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23A2DB47-2A25-4282-851B-298699A36F33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741906" y="6530024"/>
            <a:ext cx="792000" cy="7920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0799C029-F1C3-498E-A85F-9AD8D96D8AD1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548910" y="6530024"/>
            <a:ext cx="792000" cy="7920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539636F6-C153-49B0-A96B-8B96A408C772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355914" y="6530024"/>
            <a:ext cx="792000" cy="7920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AC02450D-06AF-4EFD-9ED6-D9458D8DF93B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162918" y="6530024"/>
            <a:ext cx="792000" cy="7920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B117A612-E0F3-4D3A-8D2F-780D720C3AAD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5969923" y="6530024"/>
            <a:ext cx="792000" cy="792000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2675BB60-01AC-4CEC-8EE3-7C934D5B1BE1}"/>
              </a:ext>
            </a:extLst>
          </p:cNvPr>
          <p:cNvSpPr txBox="1"/>
          <p:nvPr/>
        </p:nvSpPr>
        <p:spPr>
          <a:xfrm>
            <a:off x="329649" y="4725182"/>
            <a:ext cx="816249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No stimulation</a:t>
            </a:r>
            <a:endParaRPr lang="he-IL" sz="8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02DADA8-35A7-47C2-ADD4-C9D90DFE6492}"/>
              </a:ext>
            </a:extLst>
          </p:cNvPr>
          <p:cNvSpPr txBox="1"/>
          <p:nvPr/>
        </p:nvSpPr>
        <p:spPr>
          <a:xfrm>
            <a:off x="1365048" y="4725182"/>
            <a:ext cx="37382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endParaRPr lang="he-IL" sz="800" b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B048F5E-EF84-43C5-9826-69A95C9129AD}"/>
              </a:ext>
            </a:extLst>
          </p:cNvPr>
          <p:cNvSpPr txBox="1"/>
          <p:nvPr/>
        </p:nvSpPr>
        <p:spPr>
          <a:xfrm>
            <a:off x="2149651" y="4720931"/>
            <a:ext cx="41069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5FEB628-4F77-486F-A802-B0B4352E40D0}"/>
              </a:ext>
            </a:extLst>
          </p:cNvPr>
          <p:cNvSpPr txBox="1"/>
          <p:nvPr/>
        </p:nvSpPr>
        <p:spPr>
          <a:xfrm>
            <a:off x="2875994" y="4720931"/>
            <a:ext cx="651140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r>
              <a:rPr lang="en-US" sz="800" b="1" dirty="0"/>
              <a:t>+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7F6A13A-C346-4AE5-A842-24C17DDA52DA}"/>
              </a:ext>
            </a:extLst>
          </p:cNvPr>
          <p:cNvSpPr txBox="1"/>
          <p:nvPr/>
        </p:nvSpPr>
        <p:spPr>
          <a:xfrm>
            <a:off x="3753711" y="4726608"/>
            <a:ext cx="396262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hypo</a:t>
            </a:r>
            <a:endParaRPr lang="he-IL" sz="8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05C64F6-84F7-45C9-B9B4-7BB5D752CDE5}"/>
              </a:ext>
            </a:extLst>
          </p:cNvPr>
          <p:cNvSpPr txBox="1"/>
          <p:nvPr/>
        </p:nvSpPr>
        <p:spPr>
          <a:xfrm>
            <a:off x="4422485" y="4725262"/>
            <a:ext cx="64633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 err="1"/>
              <a:t>Hypo+IFN</a:t>
            </a:r>
            <a:r>
              <a:rPr lang="el-GR" sz="800" b="1" dirty="0"/>
              <a:t>γ</a:t>
            </a:r>
            <a:endParaRPr lang="he-IL" sz="800" b="1" dirty="0"/>
          </a:p>
          <a:p>
            <a:pPr algn="ctr"/>
            <a:endParaRPr lang="he-IL" sz="8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9D78314-9CB3-4A9F-BB82-9307E12CF57F}"/>
              </a:ext>
            </a:extLst>
          </p:cNvPr>
          <p:cNvSpPr txBox="1"/>
          <p:nvPr/>
        </p:nvSpPr>
        <p:spPr>
          <a:xfrm>
            <a:off x="5224665" y="4720931"/>
            <a:ext cx="705642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Hypo+ TNF</a:t>
            </a:r>
            <a:r>
              <a:rPr lang="el-GR" sz="800" b="1" dirty="0"/>
              <a:t>α</a:t>
            </a:r>
            <a:endParaRPr lang="he-IL" sz="8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7F4AE6E-3273-4351-8412-0FF462625FBF}"/>
              </a:ext>
            </a:extLst>
          </p:cNvPr>
          <p:cNvSpPr txBox="1"/>
          <p:nvPr/>
        </p:nvSpPr>
        <p:spPr>
          <a:xfrm>
            <a:off x="5944641" y="4720258"/>
            <a:ext cx="914033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b="1" dirty="0"/>
              <a:t>IFN</a:t>
            </a:r>
            <a:r>
              <a:rPr lang="el-GR" sz="800" b="1" dirty="0"/>
              <a:t>γ</a:t>
            </a:r>
            <a:r>
              <a:rPr lang="en-US" sz="800" b="1" dirty="0"/>
              <a:t>+TNF</a:t>
            </a:r>
            <a:r>
              <a:rPr lang="el-GR" sz="800" b="1" dirty="0"/>
              <a:t>α</a:t>
            </a:r>
            <a:r>
              <a:rPr lang="en-US" sz="800" b="1" dirty="0"/>
              <a:t>+hypo</a:t>
            </a:r>
            <a:endParaRPr lang="he-IL" sz="800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8E157D2-1E73-4657-B0FD-870BA8F7AF13}"/>
              </a:ext>
            </a:extLst>
          </p:cNvPr>
          <p:cNvSpPr txBox="1"/>
          <p:nvPr/>
        </p:nvSpPr>
        <p:spPr>
          <a:xfrm rot="16200000">
            <a:off x="-42549" y="5072520"/>
            <a:ext cx="593432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Mini TK</a:t>
            </a:r>
            <a:endParaRPr lang="he-IL" sz="10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CDDADC0-4479-4226-88DD-75890AC49ED0}"/>
              </a:ext>
            </a:extLst>
          </p:cNvPr>
          <p:cNvSpPr txBox="1"/>
          <p:nvPr/>
        </p:nvSpPr>
        <p:spPr>
          <a:xfrm rot="16200000">
            <a:off x="-102662" y="5960875"/>
            <a:ext cx="713657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Mini CMV</a:t>
            </a:r>
            <a:endParaRPr lang="he-IL" sz="1000" b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B652A56-200D-44FB-B2ED-0C3397AACA5C}"/>
              </a:ext>
            </a:extLst>
          </p:cNvPr>
          <p:cNvSpPr txBox="1"/>
          <p:nvPr/>
        </p:nvSpPr>
        <p:spPr>
          <a:xfrm rot="16200000">
            <a:off x="-64354" y="6806026"/>
            <a:ext cx="670376" cy="203488"/>
          </a:xfrm>
          <a:prstGeom prst="rect">
            <a:avLst/>
          </a:prstGeom>
          <a:solidFill>
            <a:schemeClr val="bg1"/>
          </a:solidFill>
        </p:spPr>
        <p:txBody>
          <a:bodyPr wrap="none" rtlCol="1">
            <a:spAutoFit/>
          </a:bodyPr>
          <a:lstStyle/>
          <a:p>
            <a:pPr algn="ctr"/>
            <a:r>
              <a:rPr lang="en-US" sz="1000" b="1" dirty="0"/>
              <a:t>YB_TATA</a:t>
            </a:r>
            <a:endParaRPr lang="he-IL" sz="1000" b="1" dirty="0"/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6DE24E0E-7D32-4724-966B-26CC70D0CCD0}"/>
              </a:ext>
            </a:extLst>
          </p:cNvPr>
          <p:cNvCxnSpPr/>
          <p:nvPr/>
        </p:nvCxnSpPr>
        <p:spPr>
          <a:xfrm flipV="1">
            <a:off x="179058" y="4750582"/>
            <a:ext cx="16668" cy="267727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291420FE-EDCB-4ECB-8FF1-BE86F39C46AC}"/>
              </a:ext>
            </a:extLst>
          </p:cNvPr>
          <p:cNvCxnSpPr/>
          <p:nvPr/>
        </p:nvCxnSpPr>
        <p:spPr>
          <a:xfrm>
            <a:off x="172373" y="7427860"/>
            <a:ext cx="664868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A1942587-6C75-448D-A5CA-5C9C2233DCFD}"/>
              </a:ext>
            </a:extLst>
          </p:cNvPr>
          <p:cNvSpPr txBox="1"/>
          <p:nvPr/>
        </p:nvSpPr>
        <p:spPr>
          <a:xfrm>
            <a:off x="3259263" y="7438608"/>
            <a:ext cx="582211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RFP670</a:t>
            </a:r>
            <a:endParaRPr lang="he-IL" sz="10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B4F6110-C7EE-4603-B86E-D589094B57BA}"/>
              </a:ext>
            </a:extLst>
          </p:cNvPr>
          <p:cNvSpPr txBox="1"/>
          <p:nvPr/>
        </p:nvSpPr>
        <p:spPr>
          <a:xfrm rot="16200000">
            <a:off x="-264362" y="6128383"/>
            <a:ext cx="620683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 err="1"/>
              <a:t>ZsGreen</a:t>
            </a:r>
            <a:endParaRPr lang="he-IL" sz="1000" b="1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9EA4670-59BA-4616-A260-39EFAA86B4E3}"/>
              </a:ext>
            </a:extLst>
          </p:cNvPr>
          <p:cNvSpPr txBox="1"/>
          <p:nvPr/>
        </p:nvSpPr>
        <p:spPr>
          <a:xfrm>
            <a:off x="132578" y="2266763"/>
            <a:ext cx="28725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b.</a:t>
            </a:r>
            <a:endParaRPr lang="he-IL" sz="1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8EC9A2A-39D3-4402-9FFA-E4F6BFF7D5DC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433021" y="2348223"/>
            <a:ext cx="3408453" cy="20459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35702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58427363-F1FC-4919-A532-7F244108B3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4231" y="438090"/>
            <a:ext cx="1420069" cy="1440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BE910B7-AE4A-40FE-B419-F3216A3A98FD}"/>
              </a:ext>
            </a:extLst>
          </p:cNvPr>
          <p:cNvSpPr txBox="1"/>
          <p:nvPr/>
        </p:nvSpPr>
        <p:spPr>
          <a:xfrm>
            <a:off x="234950" y="4234299"/>
            <a:ext cx="6388100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Supplementary figure S4 –   </a:t>
            </a:r>
            <a:r>
              <a:rPr lang="en-US" sz="1000" dirty="0"/>
              <a:t>the gating scheme used for degranulation in human primary T cells</a:t>
            </a:r>
            <a:r>
              <a:rPr lang="en-US" sz="1000" b="1" dirty="0"/>
              <a:t>. </a:t>
            </a:r>
            <a:r>
              <a:rPr lang="en-US" sz="1000" dirty="0"/>
              <a:t>showing non stimulated human primary T cells 4D5 CAR construct under the control of G1K06H1 </a:t>
            </a:r>
            <a:r>
              <a:rPr lang="en-US" sz="1000" dirty="0" err="1"/>
              <a:t>miniTK</a:t>
            </a:r>
            <a:r>
              <a:rPr lang="en-US" sz="1000" dirty="0"/>
              <a:t> promotor and a </a:t>
            </a:r>
            <a:r>
              <a:rPr lang="en-US" sz="1000" dirty="0" err="1"/>
              <a:t>ZsGreen</a:t>
            </a:r>
            <a:r>
              <a:rPr lang="en-US" sz="1000" dirty="0"/>
              <a:t> reporter under the control of a ef1</a:t>
            </a:r>
            <a:r>
              <a:rPr lang="el-GR" sz="1000" dirty="0"/>
              <a:t>α</a:t>
            </a:r>
            <a:r>
              <a:rPr lang="en-US" sz="1000" dirty="0"/>
              <a:t> core promotor. A logic gate composed of FS-SS AND single AND NOT DAPI+ was used to define live cells. CD107a+ cells gate was set according to the </a:t>
            </a:r>
            <a:r>
              <a:rPr lang="en-US" sz="1000" dirty="0" err="1"/>
              <a:t>untransduced</a:t>
            </a:r>
            <a:r>
              <a:rPr lang="en-US" sz="1000" dirty="0"/>
              <a:t> cells </a:t>
            </a:r>
            <a:r>
              <a:rPr lang="en-US" sz="1000" b="1" dirty="0"/>
              <a:t>b.</a:t>
            </a:r>
            <a:r>
              <a:rPr lang="en-US" sz="1000" dirty="0"/>
              <a:t> average from triplicates of the CAR+ cells from  the </a:t>
            </a:r>
            <a:r>
              <a:rPr lang="en-US" sz="1000" dirty="0" err="1"/>
              <a:t>ZsGreen</a:t>
            </a:r>
            <a:r>
              <a:rPr lang="en-US" sz="1000" dirty="0"/>
              <a:t> positive fraction, normalized to the total %</a:t>
            </a:r>
            <a:r>
              <a:rPr lang="en-US" sz="1000" dirty="0" err="1"/>
              <a:t>ZsGreen</a:t>
            </a:r>
            <a:r>
              <a:rPr lang="en-US" sz="1000" dirty="0"/>
              <a:t> positive cells. Cells stained using 5µg/ml of ERBB2-FC recombinant protein followed by 2</a:t>
            </a:r>
            <a:r>
              <a:rPr lang="en-US" sz="1000" baseline="30000" dirty="0"/>
              <a:t>nd</a:t>
            </a:r>
            <a:r>
              <a:rPr lang="en-US" sz="1000" dirty="0"/>
              <a:t> antibody anti-human APC.</a:t>
            </a:r>
            <a:endParaRPr lang="he-IL" sz="1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8FBE4F8-3C1C-4393-9B8A-CE2BAD147C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2727" y="413188"/>
            <a:ext cx="1440000" cy="144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B6F5398-B26A-4F27-B86F-24E7F35DA2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95804" y="413188"/>
            <a:ext cx="1440000" cy="144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AF565DD-C730-4C16-876A-9E12CC7EAB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57307" y="413188"/>
            <a:ext cx="1440000" cy="1440000"/>
          </a:xfrm>
          <a:prstGeom prst="rect">
            <a:avLst/>
          </a:prstGeom>
        </p:spPr>
      </p:pic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7A6766B-0879-412C-93F0-2AAAC1EB4DBB}"/>
              </a:ext>
            </a:extLst>
          </p:cNvPr>
          <p:cNvCxnSpPr>
            <a:cxnSpLocks/>
          </p:cNvCxnSpPr>
          <p:nvPr/>
        </p:nvCxnSpPr>
        <p:spPr>
          <a:xfrm flipV="1">
            <a:off x="1390650" y="196850"/>
            <a:ext cx="0" cy="62865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6988AC9C-3BF9-46A8-AB0D-3E168812396D}"/>
              </a:ext>
            </a:extLst>
          </p:cNvPr>
          <p:cNvCxnSpPr>
            <a:cxnSpLocks/>
          </p:cNvCxnSpPr>
          <p:nvPr/>
        </p:nvCxnSpPr>
        <p:spPr>
          <a:xfrm>
            <a:off x="1390650" y="196850"/>
            <a:ext cx="43581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3C2BB95-53CC-4F7C-A596-3DAAB8007063}"/>
              </a:ext>
            </a:extLst>
          </p:cNvPr>
          <p:cNvCxnSpPr>
            <a:cxnSpLocks/>
          </p:cNvCxnSpPr>
          <p:nvPr/>
        </p:nvCxnSpPr>
        <p:spPr>
          <a:xfrm flipV="1">
            <a:off x="2573270" y="188039"/>
            <a:ext cx="0" cy="100964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58E1CF26-6D19-41D8-94CC-03690AAB9667}"/>
              </a:ext>
            </a:extLst>
          </p:cNvPr>
          <p:cNvSpPr txBox="1"/>
          <p:nvPr/>
        </p:nvSpPr>
        <p:spPr>
          <a:xfrm>
            <a:off x="4245713" y="196849"/>
            <a:ext cx="420308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NOT</a:t>
            </a:r>
            <a:endParaRPr lang="he-IL" sz="1000" b="1" dirty="0"/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81D3151C-03C3-4B1D-9A1B-B1EF60F62D1B}"/>
              </a:ext>
            </a:extLst>
          </p:cNvPr>
          <p:cNvCxnSpPr/>
          <p:nvPr/>
        </p:nvCxnSpPr>
        <p:spPr>
          <a:xfrm>
            <a:off x="5748750" y="196849"/>
            <a:ext cx="0" cy="203201"/>
          </a:xfrm>
          <a:prstGeom prst="straightConnector1">
            <a:avLst/>
          </a:prstGeom>
          <a:ln w="19050">
            <a:headEnd type="non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2BBFAC9-65EB-409C-9B57-4D3D7B4E46BE}"/>
              </a:ext>
            </a:extLst>
          </p:cNvPr>
          <p:cNvCxnSpPr>
            <a:cxnSpLocks/>
          </p:cNvCxnSpPr>
          <p:nvPr/>
        </p:nvCxnSpPr>
        <p:spPr>
          <a:xfrm flipV="1">
            <a:off x="4603750" y="196850"/>
            <a:ext cx="0" cy="39052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8C8C13A-DB9C-4F11-B296-26FFE22044A9}"/>
              </a:ext>
            </a:extLst>
          </p:cNvPr>
          <p:cNvSpPr txBox="1"/>
          <p:nvPr/>
        </p:nvSpPr>
        <p:spPr>
          <a:xfrm>
            <a:off x="2212443" y="196849"/>
            <a:ext cx="426720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ND</a:t>
            </a:r>
            <a:endParaRPr lang="he-IL" sz="10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A14AEEA-A0C8-40EB-9641-A35FB01EA3ED}"/>
              </a:ext>
            </a:extLst>
          </p:cNvPr>
          <p:cNvSpPr txBox="1"/>
          <p:nvPr/>
        </p:nvSpPr>
        <p:spPr>
          <a:xfrm>
            <a:off x="1021363" y="188039"/>
            <a:ext cx="426720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ND</a:t>
            </a:r>
            <a:endParaRPr lang="he-IL" sz="10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5FB5A21-FBB5-438C-8AE1-99FCEA716AB4}"/>
              </a:ext>
            </a:extLst>
          </p:cNvPr>
          <p:cNvSpPr txBox="1"/>
          <p:nvPr/>
        </p:nvSpPr>
        <p:spPr>
          <a:xfrm>
            <a:off x="101600" y="92123"/>
            <a:ext cx="295274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A.</a:t>
            </a:r>
            <a:endParaRPr lang="he-IL" sz="100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510834B-57E6-4A28-AB68-1E9DE7417ED3}"/>
              </a:ext>
            </a:extLst>
          </p:cNvPr>
          <p:cNvSpPr txBox="1"/>
          <p:nvPr/>
        </p:nvSpPr>
        <p:spPr>
          <a:xfrm>
            <a:off x="104206" y="2015187"/>
            <a:ext cx="290464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/>
              <a:t>B.</a:t>
            </a:r>
            <a:endParaRPr lang="he-IL" sz="10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93D6827-1809-41BC-B654-43D3AD7A3D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536" y="2185741"/>
            <a:ext cx="3397828" cy="2048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61931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6BE910B7-AE4A-40FE-B419-F3216A3A98FD}"/>
              </a:ext>
            </a:extLst>
          </p:cNvPr>
          <p:cNvSpPr txBox="1"/>
          <p:nvPr/>
        </p:nvSpPr>
        <p:spPr>
          <a:xfrm>
            <a:off x="266700" y="5347781"/>
            <a:ext cx="63881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Supplementary figure S5 – the promotors and the CAR used : </a:t>
            </a:r>
            <a:r>
              <a:rPr lang="en-US" sz="1000" dirty="0"/>
              <a:t> turquois – </a:t>
            </a:r>
            <a:r>
              <a:rPr lang="en-US" sz="1000" dirty="0" err="1"/>
              <a:t>NFκB</a:t>
            </a:r>
            <a:r>
              <a:rPr lang="en-US" sz="1000" dirty="0"/>
              <a:t> element, yellow- GAS element, green – Hypoxia element, pink – TATA box, in Italic the indicated minimal promotor</a:t>
            </a:r>
            <a:endParaRPr lang="he-IL" sz="10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8F27479-9ED0-4DFB-BEA4-4F455432587E}"/>
              </a:ext>
            </a:extLst>
          </p:cNvPr>
          <p:cNvSpPr txBox="1"/>
          <p:nvPr/>
        </p:nvSpPr>
        <p:spPr>
          <a:xfrm>
            <a:off x="266700" y="484911"/>
            <a:ext cx="6388100" cy="486287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u="sng" dirty="0"/>
              <a:t>G1K06H1 mini TK</a:t>
            </a:r>
            <a:endParaRPr lang="en-US" sz="1000" b="1" dirty="0"/>
          </a:p>
          <a:p>
            <a:r>
              <a:rPr lang="en-US" sz="1000" dirty="0">
                <a:solidFill>
                  <a:schemeClr val="dk1"/>
                </a:solidFill>
                <a:highlight>
                  <a:srgbClr val="FFFF00"/>
                </a:highlight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TTCCGGGAAAGGGTGGGCAAGTTTCCGGGAA</a:t>
            </a:r>
            <a:r>
              <a:rPr lang="en-US" sz="1000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ccc</a:t>
            </a:r>
            <a:r>
              <a:rPr lang="en-US" sz="1000" dirty="0">
                <a:solidFill>
                  <a:schemeClr val="dk1"/>
                </a:solidFill>
                <a:highlight>
                  <a:srgbClr val="00FFFF"/>
                </a:highlight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GGGAATTTCCGGGGACTTTCCGGGAATTTCC</a:t>
            </a:r>
            <a:r>
              <a:rPr lang="en-US" sz="1000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taca</a:t>
            </a:r>
            <a:r>
              <a:rPr lang="en-US" sz="1000" dirty="0">
                <a:solidFill>
                  <a:schemeClr val="dk1"/>
                </a:solidFill>
                <a:highlight>
                  <a:srgbClr val="00FF00"/>
                </a:highlight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GACCTTGAGTACGTGCGTCTCTGCACGTATG</a:t>
            </a:r>
            <a:r>
              <a:rPr lang="en-US" sz="1000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AGAGCA</a:t>
            </a:r>
            <a:r>
              <a:rPr lang="en-US" sz="1000" dirty="0">
                <a:solidFill>
                  <a:schemeClr val="dk1"/>
                </a:solidFill>
                <a:highlight>
                  <a:srgbClr val="FF00FF"/>
                </a:highlight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TATTA</a:t>
            </a:r>
            <a:r>
              <a:rPr lang="en-US" sz="1000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AGGTG</a:t>
            </a:r>
            <a:r>
              <a:rPr lang="en-US" sz="1000" i="1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ACGCGTGTGGCCTCGAACACCGAGCGACCCTGCAGCGACCCGCTTAAAA</a:t>
            </a:r>
          </a:p>
          <a:p>
            <a:endParaRPr lang="en-US" sz="1000" b="1" u="sng" dirty="0">
              <a:highlight>
                <a:srgbClr val="C0C0C0"/>
              </a:highlight>
            </a:endParaRPr>
          </a:p>
          <a:p>
            <a:r>
              <a:rPr lang="en-US" sz="1000" b="1" u="sng" dirty="0"/>
              <a:t>G1K06H1 mini CMV</a:t>
            </a:r>
          </a:p>
          <a:p>
            <a:r>
              <a:rPr lang="en-US" sz="1000" dirty="0">
                <a:highlight>
                  <a:srgbClr val="FFFF00"/>
                </a:highlight>
              </a:rPr>
              <a:t>TTCCGGGAAAGGGTGGGCAAGTTTCCGGGAA</a:t>
            </a:r>
            <a:r>
              <a:rPr lang="en-US" sz="1000" dirty="0"/>
              <a:t>ccc</a:t>
            </a:r>
            <a:r>
              <a:rPr lang="en-US" sz="1000" dirty="0">
                <a:highlight>
                  <a:srgbClr val="00FFFF"/>
                </a:highlight>
              </a:rPr>
              <a:t>GGGAATTTCCGGGGACTTTCCGGGAATTTCC</a:t>
            </a:r>
            <a:r>
              <a:rPr lang="en-US" sz="1000" dirty="0"/>
              <a:t>taca</a:t>
            </a:r>
            <a:r>
              <a:rPr lang="en-US" sz="1000" dirty="0">
                <a:highlight>
                  <a:srgbClr val="00FF00"/>
                </a:highlight>
              </a:rPr>
              <a:t>GACCTTGAGTACGTGCGTCTCTGCACGTATG</a:t>
            </a:r>
            <a:r>
              <a:rPr lang="en-US" sz="1000" dirty="0"/>
              <a:t>AGAGCA</a:t>
            </a:r>
            <a:r>
              <a:rPr lang="en-US" sz="1000" dirty="0">
                <a:highlight>
                  <a:srgbClr val="FF00FF"/>
                </a:highlight>
              </a:rPr>
              <a:t>TATTA</a:t>
            </a:r>
            <a:r>
              <a:rPr lang="en-US" sz="1000" dirty="0"/>
              <a:t>AGGTGacgcgt</a:t>
            </a:r>
            <a:r>
              <a:rPr lang="en-US" sz="1000" i="1" dirty="0"/>
              <a:t>GTAGGCGTGTACGGTGGGAGGTCTATATAAGCAGAGCTCGTTTAGTGAACCGTCAGATCa</a:t>
            </a:r>
          </a:p>
          <a:p>
            <a:endParaRPr lang="en-US" sz="1000" dirty="0">
              <a:solidFill>
                <a:schemeClr val="bg1"/>
              </a:solidFill>
              <a:highlight>
                <a:srgbClr val="000000"/>
              </a:highlight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  <a:p>
            <a:pPr lvl="0"/>
            <a:r>
              <a:rPr lang="en-US" sz="1000" b="1" u="sng" dirty="0">
                <a:solidFill>
                  <a:prstClr val="black"/>
                </a:solidFill>
              </a:rPr>
              <a:t>G1K06H1 YB_TATA</a:t>
            </a:r>
          </a:p>
          <a:p>
            <a:pPr lvl="0"/>
            <a:r>
              <a:rPr lang="en-US" sz="1000" dirty="0">
                <a:solidFill>
                  <a:prstClr val="black"/>
                </a:solidFill>
                <a:highlight>
                  <a:srgbClr val="FFFF00"/>
                </a:highlight>
              </a:rPr>
              <a:t>TTCCGGGAAAGGGTGGGCAAGTTTCCGGGAA</a:t>
            </a:r>
            <a:r>
              <a:rPr lang="en-US" sz="1000" dirty="0">
                <a:solidFill>
                  <a:prstClr val="black"/>
                </a:solidFill>
              </a:rPr>
              <a:t>ccc</a:t>
            </a:r>
            <a:r>
              <a:rPr lang="en-US" sz="1000" dirty="0">
                <a:solidFill>
                  <a:prstClr val="black"/>
                </a:solidFill>
                <a:highlight>
                  <a:srgbClr val="00FFFF"/>
                </a:highlight>
              </a:rPr>
              <a:t>GGGAATTTCCGGGGACTTTCCGGGAATTTCC</a:t>
            </a:r>
            <a:r>
              <a:rPr lang="en-US" sz="1000" dirty="0">
                <a:solidFill>
                  <a:prstClr val="black"/>
                </a:solidFill>
              </a:rPr>
              <a:t>taca</a:t>
            </a:r>
            <a:r>
              <a:rPr lang="en-US" sz="1000" dirty="0">
                <a:solidFill>
                  <a:prstClr val="black"/>
                </a:solidFill>
                <a:highlight>
                  <a:srgbClr val="00FF00"/>
                </a:highlight>
              </a:rPr>
              <a:t>GACCTTGAGTACGTGCGTCTCTGCACGTATG</a:t>
            </a:r>
            <a:r>
              <a:rPr lang="en-US" sz="1000" dirty="0">
                <a:solidFill>
                  <a:prstClr val="black"/>
                </a:solidFill>
              </a:rPr>
              <a:t>AGAGCA</a:t>
            </a:r>
            <a:r>
              <a:rPr lang="en-US" sz="1000" dirty="0">
                <a:solidFill>
                  <a:prstClr val="black"/>
                </a:solidFill>
                <a:highlight>
                  <a:srgbClr val="FF00FF"/>
                </a:highlight>
              </a:rPr>
              <a:t>TATTA</a:t>
            </a:r>
            <a:r>
              <a:rPr lang="en-US" sz="1000" dirty="0">
                <a:solidFill>
                  <a:prstClr val="black"/>
                </a:solidFill>
              </a:rPr>
              <a:t>AGGTGacgcgt</a:t>
            </a:r>
            <a:r>
              <a:rPr lang="en-US" sz="1000" i="1" dirty="0">
                <a:solidFill>
                  <a:prstClr val="black"/>
                </a:solidFill>
              </a:rPr>
              <a:t>GTTCTAGAGGGTATATAATGGGGGCCA</a:t>
            </a:r>
          </a:p>
          <a:p>
            <a:pPr lvl="0"/>
            <a:endParaRPr lang="en-US" sz="1000" i="1" dirty="0">
              <a:solidFill>
                <a:prstClr val="black"/>
              </a:solidFill>
            </a:endParaRPr>
          </a:p>
          <a:p>
            <a:pPr lvl="0"/>
            <a:r>
              <a:rPr lang="en-US" sz="1000" b="1" u="sng" dirty="0">
                <a:solidFill>
                  <a:prstClr val="black"/>
                </a:solidFill>
              </a:rPr>
              <a:t>Herceptin based CAR</a:t>
            </a:r>
          </a:p>
          <a:p>
            <a:pPr lvl="0"/>
            <a:r>
              <a:rPr lang="en-US" sz="1000" dirty="0">
                <a:solidFill>
                  <a:prstClr val="black"/>
                </a:solidFill>
              </a:rPr>
              <a:t>atggattttcaggtgcagattttcagcttcctgctaatcagtgcctcagtcataatgtccagaggagatatccagatgacccagtccccgagctccctgtccgcctctgtgggcgatagggtcaccatcacctgccgtgccagtcaggatgtgaatactgctgtagcctggtatcaacagaaaccaggaaaagctccgaaactactgatttactcggcatccttcctttattctggagtcccttctcgcttctctggatctagatctgggacggatttcactctgaccatcagcagtctgcagccggaagacttcgcaacttattactgtcagcaacattatactactcctcccacgttcggacagggtaccaaggtggagatcaaacgcactgggtctacatctggatctgggaagccgggttctggtgagggttctgaggttcagctggtggagtctggcggtggcctggtgcagccagggggctcactccgtttgtcctgtgcagcttctggcttcaacattaaagacacctatatacactgggtgcgtcaggccccgggtaagggcctggaatgggttgcaaggatttatcctacgaatggttatactagatatgccgatagcgtcaagggccgtttcactataagcgcagacacatccaaaaacacagcctacctgcagatgaacagcctgcgtgctgaggacactgccgtctattattgttctagatggggaggggacggcttctatgctatggacgtgtggggtcaaggaaccctggtcaccgtctcctcgctcgaggaacaaaaactcatctcagaagaggatctgttcgtgccggtcttcctgccagcgaagcccaccacgacgccagcgccgcgaccaccaacaccggcgcccaccatcgcgtcgcagcccctgtccctgcgcccagaggcgtgccggccagcggcggggggcgcagtgcacacgagggggctggacttcgcctgtgatatctacatctgggcgcccttggccgggacttgtggggtccttctcctgtcactggttatcaccctttactgcaaccacaggaacaggagtaagaggagcaggctcctgcacagtgactacatgaacatgactccccgccgccccgggcccacccgcaagcattaccagccctatgccccaccacgcgacttcgcagcctatcgctcccgtttctctgttgttaaacggggcagaaagaagctcctgtatatattcaaacaaccatttatgagaccagtacaaactactcaagaggaagatggctgtagctgccgatttccagaagaagaagaaggaggatgtgaactgagagtgaagttcagcaggagcgcagacgcccccgcgtaccagcagggccagaaccagctctataacgagctcaatctaggacgaagagaggagtacgatgttttggacaagagacgtggccgggaccctgagatggggggaaagccgagaaggaagaaccctcaggaaggcctgtacaatgaactgcagaaagataagatggcggaggcctacagtgagattgggatgaaaggcgagcgccggaggggcaaggggcacgatggcctttaccagggtctcagtacagccaccaaggacacctacgacgcccttcacatgcaggccctgccccctcgctaa</a:t>
            </a:r>
          </a:p>
          <a:p>
            <a:pPr lvl="0"/>
            <a:endParaRPr lang="en-US" sz="1000" i="1" dirty="0">
              <a:solidFill>
                <a:prstClr val="black"/>
              </a:solidFill>
            </a:endParaRPr>
          </a:p>
          <a:p>
            <a:endParaRPr lang="en-US" sz="1000" dirty="0">
              <a:solidFill>
                <a:schemeClr val="bg1"/>
              </a:solidFill>
              <a:highlight>
                <a:srgbClr val="000000"/>
              </a:highlight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33477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מסמך" ma:contentTypeID="0x010100A064A23859AC2742B92C1BBF73AACB70" ma:contentTypeVersion="11" ma:contentTypeDescription="צור מסמך חדש." ma:contentTypeScope="" ma:versionID="4ca49d16cc27f6f5e54c016e0981f60e">
  <xsd:schema xmlns:xsd="http://www.w3.org/2001/XMLSchema" xmlns:xs="http://www.w3.org/2001/XMLSchema" xmlns:p="http://schemas.microsoft.com/office/2006/metadata/properties" xmlns:ns3="1e6b9c30-ef70-4a65-b630-4eb845941252" targetNamespace="http://schemas.microsoft.com/office/2006/metadata/properties" ma:root="true" ma:fieldsID="d4666de0a0ebea26ac301665561486de" ns3:_="">
    <xsd:import namespace="1e6b9c30-ef70-4a65-b630-4eb84594125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6b9c30-ef70-4a65-b630-4eb84594125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סוג תוכן"/>
        <xsd:element ref="dc:title" minOccurs="0" maxOccurs="1" ma:index="4" ma:displayName="כותרת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29BA359-F069-45F1-AAE6-B82FA487A11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264F2A9-92E5-4407-A142-D8F3CE898224}">
  <ds:schemaRefs>
    <ds:schemaRef ds:uri="http://www.w3.org/XML/1998/namespace"/>
    <ds:schemaRef ds:uri="1e6b9c30-ef70-4a65-b630-4eb845941252"/>
    <ds:schemaRef ds:uri="http://purl.org/dc/elements/1.1/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http://schemas.openxmlformats.org/package/2006/metadata/core-propertie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03B682F0-A07D-4D6A-B666-195095865F8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6b9c30-ef70-4a65-b630-4eb84594125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730</Words>
  <Application>Microsoft Office PowerPoint</Application>
  <PresentationFormat>A4 Paper (210x297 mm)</PresentationFormat>
  <Paragraphs>7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יריב גרינשפן</dc:creator>
  <cp:lastModifiedBy>MDPI</cp:lastModifiedBy>
  <cp:revision>5</cp:revision>
  <dcterms:created xsi:type="dcterms:W3CDTF">2021-07-28T09:31:48Z</dcterms:created>
  <dcterms:modified xsi:type="dcterms:W3CDTF">2022-07-04T06:57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064A23859AC2742B92C1BBF73AACB70</vt:lpwstr>
  </property>
</Properties>
</file>